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5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 snapToObjects="1">
      <p:cViewPr varScale="1">
        <p:scale>
          <a:sx n="114" d="100"/>
          <a:sy n="114" d="100"/>
        </p:scale>
        <p:origin x="-4240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78DE05-16BB-AF42-9B56-FAC9A656A2E7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E43F3F-D121-9E48-B9F1-9BD95C8F4C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5618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686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82058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44109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5256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6607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9299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0776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87141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5105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4743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8748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3659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272"/>
          <p:cNvGrpSpPr/>
          <p:nvPr/>
        </p:nvGrpSpPr>
        <p:grpSpPr>
          <a:xfrm>
            <a:off x="2199158" y="4585493"/>
            <a:ext cx="2007225" cy="2279175"/>
            <a:chOff x="399611" y="1393479"/>
            <a:chExt cx="2007690" cy="2279571"/>
          </a:xfrm>
        </p:grpSpPr>
        <p:sp>
          <p:nvSpPr>
            <p:cNvPr id="5" name="Line 1029"/>
            <p:cNvSpPr>
              <a:spLocks noChangeShapeType="1"/>
            </p:cNvSpPr>
            <p:nvPr/>
          </p:nvSpPr>
          <p:spPr bwMode="auto">
            <a:xfrm>
              <a:off x="1763688" y="2119641"/>
              <a:ext cx="540000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Arc 1030"/>
            <p:cNvSpPr>
              <a:spLocks/>
            </p:cNvSpPr>
            <p:nvPr/>
          </p:nvSpPr>
          <p:spPr bwMode="auto">
            <a:xfrm>
              <a:off x="2006548" y="2418091"/>
              <a:ext cx="82800" cy="82800"/>
            </a:xfrm>
            <a:custGeom>
              <a:avLst/>
              <a:gdLst>
                <a:gd name="G0" fmla="+- 21600 0 0"/>
                <a:gd name="G1" fmla="+- 21600 0 0"/>
                <a:gd name="G2" fmla="+- 21600 0 0"/>
                <a:gd name="T0" fmla="*/ 43179 w 43200"/>
                <a:gd name="T1" fmla="*/ 22538 h 43200"/>
                <a:gd name="T2" fmla="*/ 43179 w 43200"/>
                <a:gd name="T3" fmla="*/ 22538 h 43200"/>
                <a:gd name="T4" fmla="*/ 21600 w 43200"/>
                <a:gd name="T5" fmla="*/ 21600 h 43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200" h="43200" fill="none" extrusionOk="0">
                  <a:moveTo>
                    <a:pt x="43179" y="22538"/>
                  </a:moveTo>
                  <a:cubicBezTo>
                    <a:pt x="42677" y="34091"/>
                    <a:pt x="33164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0" y="9670"/>
                    <a:pt x="9670" y="0"/>
                    <a:pt x="21600" y="0"/>
                  </a:cubicBezTo>
                  <a:cubicBezTo>
                    <a:pt x="33529" y="0"/>
                    <a:pt x="43200" y="9670"/>
                    <a:pt x="43200" y="21600"/>
                  </a:cubicBezTo>
                  <a:cubicBezTo>
                    <a:pt x="43200" y="21912"/>
                    <a:pt x="43193" y="22225"/>
                    <a:pt x="43179" y="22538"/>
                  </a:cubicBezTo>
                </a:path>
                <a:path w="43200" h="43200" stroke="0" extrusionOk="0">
                  <a:moveTo>
                    <a:pt x="43179" y="22538"/>
                  </a:moveTo>
                  <a:cubicBezTo>
                    <a:pt x="42677" y="34091"/>
                    <a:pt x="33164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0" y="9670"/>
                    <a:pt x="9670" y="0"/>
                    <a:pt x="21600" y="0"/>
                  </a:cubicBezTo>
                  <a:cubicBezTo>
                    <a:pt x="33529" y="0"/>
                    <a:pt x="43200" y="9670"/>
                    <a:pt x="43200" y="21600"/>
                  </a:cubicBezTo>
                  <a:cubicBezTo>
                    <a:pt x="43200" y="21912"/>
                    <a:pt x="43193" y="22225"/>
                    <a:pt x="43179" y="22538"/>
                  </a:cubicBezTo>
                  <a:lnTo>
                    <a:pt x="21600" y="2160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Arc 1032"/>
            <p:cNvSpPr>
              <a:spLocks/>
            </p:cNvSpPr>
            <p:nvPr/>
          </p:nvSpPr>
          <p:spPr bwMode="auto">
            <a:xfrm>
              <a:off x="2061366" y="2125991"/>
              <a:ext cx="82800" cy="82800"/>
            </a:xfrm>
            <a:custGeom>
              <a:avLst/>
              <a:gdLst>
                <a:gd name="G0" fmla="+- 21600 0 0"/>
                <a:gd name="G1" fmla="+- 21600 0 0"/>
                <a:gd name="G2" fmla="+- 21600 0 0"/>
                <a:gd name="T0" fmla="*/ 43179 w 43200"/>
                <a:gd name="T1" fmla="*/ 22538 h 43200"/>
                <a:gd name="T2" fmla="*/ 43179 w 43200"/>
                <a:gd name="T3" fmla="*/ 22538 h 43200"/>
                <a:gd name="T4" fmla="*/ 21600 w 43200"/>
                <a:gd name="T5" fmla="*/ 21600 h 43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200" h="43200" fill="none" extrusionOk="0">
                  <a:moveTo>
                    <a:pt x="43179" y="22538"/>
                  </a:moveTo>
                  <a:cubicBezTo>
                    <a:pt x="42677" y="34091"/>
                    <a:pt x="33164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0" y="9670"/>
                    <a:pt x="9670" y="0"/>
                    <a:pt x="21600" y="0"/>
                  </a:cubicBezTo>
                  <a:cubicBezTo>
                    <a:pt x="33529" y="0"/>
                    <a:pt x="43200" y="9670"/>
                    <a:pt x="43200" y="21600"/>
                  </a:cubicBezTo>
                  <a:cubicBezTo>
                    <a:pt x="43200" y="21912"/>
                    <a:pt x="43193" y="22225"/>
                    <a:pt x="43179" y="22538"/>
                  </a:cubicBezTo>
                </a:path>
                <a:path w="43200" h="43200" stroke="0" extrusionOk="0">
                  <a:moveTo>
                    <a:pt x="43179" y="22538"/>
                  </a:moveTo>
                  <a:cubicBezTo>
                    <a:pt x="42677" y="34091"/>
                    <a:pt x="33164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0" y="9670"/>
                    <a:pt x="9670" y="0"/>
                    <a:pt x="21600" y="0"/>
                  </a:cubicBezTo>
                  <a:cubicBezTo>
                    <a:pt x="33529" y="0"/>
                    <a:pt x="43200" y="9670"/>
                    <a:pt x="43200" y="21600"/>
                  </a:cubicBezTo>
                  <a:cubicBezTo>
                    <a:pt x="43200" y="21912"/>
                    <a:pt x="43193" y="22225"/>
                    <a:pt x="43179" y="22538"/>
                  </a:cubicBezTo>
                  <a:lnTo>
                    <a:pt x="21600" y="2160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Arc 1034"/>
            <p:cNvSpPr>
              <a:spLocks/>
            </p:cNvSpPr>
            <p:nvPr/>
          </p:nvSpPr>
          <p:spPr bwMode="auto">
            <a:xfrm>
              <a:off x="1938646" y="2016454"/>
              <a:ext cx="82800" cy="82800"/>
            </a:xfrm>
            <a:custGeom>
              <a:avLst/>
              <a:gdLst>
                <a:gd name="G0" fmla="+- 21600 0 0"/>
                <a:gd name="G1" fmla="+- 21600 0 0"/>
                <a:gd name="G2" fmla="+- 21600 0 0"/>
                <a:gd name="T0" fmla="*/ 43179 w 43200"/>
                <a:gd name="T1" fmla="*/ 22538 h 43200"/>
                <a:gd name="T2" fmla="*/ 43179 w 43200"/>
                <a:gd name="T3" fmla="*/ 22538 h 43200"/>
                <a:gd name="T4" fmla="*/ 21600 w 43200"/>
                <a:gd name="T5" fmla="*/ 21600 h 43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200" h="43200" fill="none" extrusionOk="0">
                  <a:moveTo>
                    <a:pt x="43179" y="22538"/>
                  </a:moveTo>
                  <a:cubicBezTo>
                    <a:pt x="42677" y="34091"/>
                    <a:pt x="33164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0" y="9670"/>
                    <a:pt x="9670" y="0"/>
                    <a:pt x="21600" y="0"/>
                  </a:cubicBezTo>
                  <a:cubicBezTo>
                    <a:pt x="33529" y="0"/>
                    <a:pt x="43200" y="9670"/>
                    <a:pt x="43200" y="21600"/>
                  </a:cubicBezTo>
                  <a:cubicBezTo>
                    <a:pt x="43200" y="21912"/>
                    <a:pt x="43193" y="22225"/>
                    <a:pt x="43179" y="22538"/>
                  </a:cubicBezTo>
                </a:path>
                <a:path w="43200" h="43200" stroke="0" extrusionOk="0">
                  <a:moveTo>
                    <a:pt x="43179" y="22538"/>
                  </a:moveTo>
                  <a:cubicBezTo>
                    <a:pt x="42677" y="34091"/>
                    <a:pt x="33164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0" y="9670"/>
                    <a:pt x="9670" y="0"/>
                    <a:pt x="21600" y="0"/>
                  </a:cubicBezTo>
                  <a:cubicBezTo>
                    <a:pt x="33529" y="0"/>
                    <a:pt x="43200" y="9670"/>
                    <a:pt x="43200" y="21600"/>
                  </a:cubicBezTo>
                  <a:cubicBezTo>
                    <a:pt x="43200" y="21912"/>
                    <a:pt x="43193" y="22225"/>
                    <a:pt x="43179" y="22538"/>
                  </a:cubicBezTo>
                  <a:lnTo>
                    <a:pt x="21600" y="2160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Arc 1036"/>
            <p:cNvSpPr>
              <a:spLocks/>
            </p:cNvSpPr>
            <p:nvPr/>
          </p:nvSpPr>
          <p:spPr bwMode="auto">
            <a:xfrm>
              <a:off x="2013800" y="1802141"/>
              <a:ext cx="82800" cy="82800"/>
            </a:xfrm>
            <a:custGeom>
              <a:avLst/>
              <a:gdLst>
                <a:gd name="G0" fmla="+- 21600 0 0"/>
                <a:gd name="G1" fmla="+- 21600 0 0"/>
                <a:gd name="G2" fmla="+- 21600 0 0"/>
                <a:gd name="T0" fmla="*/ 43200 w 43200"/>
                <a:gd name="T1" fmla="*/ 21600 h 43200"/>
                <a:gd name="T2" fmla="*/ 43200 w 43200"/>
                <a:gd name="T3" fmla="*/ 21600 h 43200"/>
                <a:gd name="T4" fmla="*/ 21600 w 43200"/>
                <a:gd name="T5" fmla="*/ 21600 h 43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200" h="43200" fill="none" extrusionOk="0">
                  <a:moveTo>
                    <a:pt x="43200" y="21600"/>
                  </a:moveTo>
                  <a:cubicBezTo>
                    <a:pt x="43200" y="33529"/>
                    <a:pt x="33529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0" y="9670"/>
                    <a:pt x="9670" y="0"/>
                    <a:pt x="21600" y="0"/>
                  </a:cubicBezTo>
                  <a:cubicBezTo>
                    <a:pt x="33529" y="-1"/>
                    <a:pt x="43199" y="9670"/>
                    <a:pt x="43200" y="21599"/>
                  </a:cubicBezTo>
                </a:path>
                <a:path w="43200" h="43200" stroke="0" extrusionOk="0">
                  <a:moveTo>
                    <a:pt x="43200" y="21600"/>
                  </a:moveTo>
                  <a:cubicBezTo>
                    <a:pt x="43200" y="33529"/>
                    <a:pt x="33529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0" y="9670"/>
                    <a:pt x="9670" y="0"/>
                    <a:pt x="21600" y="0"/>
                  </a:cubicBezTo>
                  <a:cubicBezTo>
                    <a:pt x="33529" y="-1"/>
                    <a:pt x="43199" y="9670"/>
                    <a:pt x="43200" y="21599"/>
                  </a:cubicBezTo>
                  <a:lnTo>
                    <a:pt x="21600" y="2160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Line 1038"/>
            <p:cNvSpPr>
              <a:spLocks noChangeShapeType="1"/>
            </p:cNvSpPr>
            <p:nvPr/>
          </p:nvSpPr>
          <p:spPr bwMode="auto">
            <a:xfrm>
              <a:off x="1115616" y="3299154"/>
              <a:ext cx="540000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Arc 1040"/>
            <p:cNvSpPr>
              <a:spLocks/>
            </p:cNvSpPr>
            <p:nvPr/>
          </p:nvSpPr>
          <p:spPr bwMode="auto">
            <a:xfrm>
              <a:off x="1341954" y="3335666"/>
              <a:ext cx="82800" cy="82800"/>
            </a:xfrm>
            <a:custGeom>
              <a:avLst/>
              <a:gdLst>
                <a:gd name="G0" fmla="+- 21600 0 0"/>
                <a:gd name="G1" fmla="+- 21600 0 0"/>
                <a:gd name="G2" fmla="+- 21600 0 0"/>
                <a:gd name="T0" fmla="*/ 21600 w 43200"/>
                <a:gd name="T1" fmla="*/ 0 h 43200"/>
                <a:gd name="T2" fmla="*/ 21600 w 43200"/>
                <a:gd name="T3" fmla="*/ 0 h 43200"/>
                <a:gd name="T4" fmla="*/ 21600 w 43200"/>
                <a:gd name="T5" fmla="*/ 21600 h 43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200" h="43200" fill="none" extrusionOk="0">
                  <a:moveTo>
                    <a:pt x="21600" y="0"/>
                  </a:moveTo>
                  <a:cubicBezTo>
                    <a:pt x="33529" y="0"/>
                    <a:pt x="43200" y="9670"/>
                    <a:pt x="43200" y="21600"/>
                  </a:cubicBezTo>
                  <a:cubicBezTo>
                    <a:pt x="43200" y="33529"/>
                    <a:pt x="33529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0" y="9670"/>
                    <a:pt x="9670" y="0"/>
                    <a:pt x="21599" y="0"/>
                  </a:cubicBezTo>
                </a:path>
                <a:path w="43200" h="43200" stroke="0" extrusionOk="0">
                  <a:moveTo>
                    <a:pt x="21600" y="0"/>
                  </a:moveTo>
                  <a:cubicBezTo>
                    <a:pt x="33529" y="0"/>
                    <a:pt x="43200" y="9670"/>
                    <a:pt x="43200" y="21600"/>
                  </a:cubicBezTo>
                  <a:cubicBezTo>
                    <a:pt x="43200" y="33529"/>
                    <a:pt x="33529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0" y="9670"/>
                    <a:pt x="9670" y="0"/>
                    <a:pt x="21599" y="0"/>
                  </a:cubicBezTo>
                  <a:lnTo>
                    <a:pt x="21600" y="21600"/>
                  </a:lnTo>
                  <a:close/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Arc 1041"/>
            <p:cNvSpPr>
              <a:spLocks/>
            </p:cNvSpPr>
            <p:nvPr/>
          </p:nvSpPr>
          <p:spPr bwMode="auto">
            <a:xfrm>
              <a:off x="1464864" y="3295979"/>
              <a:ext cx="82800" cy="82800"/>
            </a:xfrm>
            <a:custGeom>
              <a:avLst/>
              <a:gdLst>
                <a:gd name="G0" fmla="+- 21600 0 0"/>
                <a:gd name="G1" fmla="+- 21600 0 0"/>
                <a:gd name="G2" fmla="+- 21600 0 0"/>
                <a:gd name="T0" fmla="*/ 43179 w 43200"/>
                <a:gd name="T1" fmla="*/ 22538 h 43200"/>
                <a:gd name="T2" fmla="*/ 43179 w 43200"/>
                <a:gd name="T3" fmla="*/ 22538 h 43200"/>
                <a:gd name="T4" fmla="*/ 21600 w 43200"/>
                <a:gd name="T5" fmla="*/ 21600 h 43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200" h="43200" fill="none" extrusionOk="0">
                  <a:moveTo>
                    <a:pt x="43179" y="22538"/>
                  </a:moveTo>
                  <a:cubicBezTo>
                    <a:pt x="42677" y="34091"/>
                    <a:pt x="33164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0" y="9670"/>
                    <a:pt x="9670" y="0"/>
                    <a:pt x="21600" y="0"/>
                  </a:cubicBezTo>
                  <a:cubicBezTo>
                    <a:pt x="33529" y="0"/>
                    <a:pt x="43200" y="9670"/>
                    <a:pt x="43200" y="21600"/>
                  </a:cubicBezTo>
                  <a:cubicBezTo>
                    <a:pt x="43200" y="21912"/>
                    <a:pt x="43193" y="22225"/>
                    <a:pt x="43179" y="22538"/>
                  </a:cubicBezTo>
                </a:path>
                <a:path w="43200" h="43200" stroke="0" extrusionOk="0">
                  <a:moveTo>
                    <a:pt x="43179" y="22538"/>
                  </a:moveTo>
                  <a:cubicBezTo>
                    <a:pt x="42677" y="34091"/>
                    <a:pt x="33164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0" y="9670"/>
                    <a:pt x="9670" y="0"/>
                    <a:pt x="21600" y="0"/>
                  </a:cubicBezTo>
                  <a:cubicBezTo>
                    <a:pt x="33529" y="0"/>
                    <a:pt x="43200" y="9670"/>
                    <a:pt x="43200" y="21600"/>
                  </a:cubicBezTo>
                  <a:cubicBezTo>
                    <a:pt x="43200" y="21912"/>
                    <a:pt x="43193" y="22225"/>
                    <a:pt x="43179" y="22538"/>
                  </a:cubicBezTo>
                  <a:lnTo>
                    <a:pt x="21600" y="21600"/>
                  </a:lnTo>
                  <a:close/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Arc 1043"/>
            <p:cNvSpPr>
              <a:spLocks/>
            </p:cNvSpPr>
            <p:nvPr/>
          </p:nvSpPr>
          <p:spPr bwMode="auto">
            <a:xfrm>
              <a:off x="1239004" y="3253116"/>
              <a:ext cx="76200" cy="76200"/>
            </a:xfrm>
            <a:custGeom>
              <a:avLst/>
              <a:gdLst>
                <a:gd name="G0" fmla="+- 21600 0 0"/>
                <a:gd name="G1" fmla="+- 21600 0 0"/>
                <a:gd name="G2" fmla="+- 21600 0 0"/>
                <a:gd name="T0" fmla="*/ 43200 w 43200"/>
                <a:gd name="T1" fmla="*/ 21600 h 43200"/>
                <a:gd name="T2" fmla="*/ 43200 w 43200"/>
                <a:gd name="T3" fmla="*/ 21600 h 43200"/>
                <a:gd name="T4" fmla="*/ 21600 w 43200"/>
                <a:gd name="T5" fmla="*/ 21600 h 43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200" h="43200" fill="none" extrusionOk="0">
                  <a:moveTo>
                    <a:pt x="43200" y="21600"/>
                  </a:moveTo>
                  <a:cubicBezTo>
                    <a:pt x="43200" y="33529"/>
                    <a:pt x="33529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0" y="9670"/>
                    <a:pt x="9670" y="0"/>
                    <a:pt x="21600" y="0"/>
                  </a:cubicBezTo>
                  <a:cubicBezTo>
                    <a:pt x="33529" y="-1"/>
                    <a:pt x="43199" y="9670"/>
                    <a:pt x="43200" y="21599"/>
                  </a:cubicBezTo>
                </a:path>
                <a:path w="43200" h="43200" stroke="0" extrusionOk="0">
                  <a:moveTo>
                    <a:pt x="43200" y="21600"/>
                  </a:moveTo>
                  <a:cubicBezTo>
                    <a:pt x="43200" y="33529"/>
                    <a:pt x="33529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0" y="9670"/>
                    <a:pt x="9670" y="0"/>
                    <a:pt x="21600" y="0"/>
                  </a:cubicBezTo>
                  <a:cubicBezTo>
                    <a:pt x="33529" y="-1"/>
                    <a:pt x="43199" y="9670"/>
                    <a:pt x="43200" y="21599"/>
                  </a:cubicBezTo>
                  <a:lnTo>
                    <a:pt x="21600" y="21600"/>
                  </a:lnTo>
                  <a:close/>
                </a:path>
              </a:pathLst>
            </a:custGeom>
            <a:noFill/>
            <a:ln w="9525">
              <a:noFill/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Arc 1044"/>
            <p:cNvSpPr>
              <a:spLocks/>
            </p:cNvSpPr>
            <p:nvPr/>
          </p:nvSpPr>
          <p:spPr bwMode="auto">
            <a:xfrm>
              <a:off x="1246070" y="3253116"/>
              <a:ext cx="82800" cy="82800"/>
            </a:xfrm>
            <a:custGeom>
              <a:avLst/>
              <a:gdLst>
                <a:gd name="G0" fmla="+- 21600 0 0"/>
                <a:gd name="G1" fmla="+- 21600 0 0"/>
                <a:gd name="G2" fmla="+- 21600 0 0"/>
                <a:gd name="T0" fmla="*/ 21600 w 43200"/>
                <a:gd name="T1" fmla="*/ 0 h 43200"/>
                <a:gd name="T2" fmla="*/ 21600 w 43200"/>
                <a:gd name="T3" fmla="*/ 0 h 43200"/>
                <a:gd name="T4" fmla="*/ 21600 w 43200"/>
                <a:gd name="T5" fmla="*/ 21600 h 43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200" h="43200" fill="none" extrusionOk="0">
                  <a:moveTo>
                    <a:pt x="21600" y="0"/>
                  </a:moveTo>
                  <a:cubicBezTo>
                    <a:pt x="33529" y="0"/>
                    <a:pt x="43200" y="9670"/>
                    <a:pt x="43200" y="21600"/>
                  </a:cubicBezTo>
                  <a:cubicBezTo>
                    <a:pt x="43200" y="33529"/>
                    <a:pt x="33529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0" y="9670"/>
                    <a:pt x="9670" y="0"/>
                    <a:pt x="21599" y="0"/>
                  </a:cubicBezTo>
                </a:path>
                <a:path w="43200" h="43200" stroke="0" extrusionOk="0">
                  <a:moveTo>
                    <a:pt x="21600" y="0"/>
                  </a:moveTo>
                  <a:cubicBezTo>
                    <a:pt x="33529" y="0"/>
                    <a:pt x="43200" y="9670"/>
                    <a:pt x="43200" y="21600"/>
                  </a:cubicBezTo>
                  <a:cubicBezTo>
                    <a:pt x="43200" y="33529"/>
                    <a:pt x="33529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0" y="9670"/>
                    <a:pt x="9670" y="0"/>
                    <a:pt x="21599" y="0"/>
                  </a:cubicBezTo>
                  <a:lnTo>
                    <a:pt x="21600" y="21600"/>
                  </a:lnTo>
                  <a:close/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Arc 1045"/>
            <p:cNvSpPr>
              <a:spLocks/>
            </p:cNvSpPr>
            <p:nvPr/>
          </p:nvSpPr>
          <p:spPr bwMode="auto">
            <a:xfrm>
              <a:off x="1361914" y="3202316"/>
              <a:ext cx="82800" cy="82800"/>
            </a:xfrm>
            <a:custGeom>
              <a:avLst/>
              <a:gdLst>
                <a:gd name="G0" fmla="+- 21600 0 0"/>
                <a:gd name="G1" fmla="+- 21600 0 0"/>
                <a:gd name="G2" fmla="+- 21600 0 0"/>
                <a:gd name="T0" fmla="*/ 43200 w 43200"/>
                <a:gd name="T1" fmla="*/ 21600 h 43200"/>
                <a:gd name="T2" fmla="*/ 43200 w 43200"/>
                <a:gd name="T3" fmla="*/ 21600 h 43200"/>
                <a:gd name="T4" fmla="*/ 21600 w 43200"/>
                <a:gd name="T5" fmla="*/ 21600 h 43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200" h="43200" fill="none" extrusionOk="0">
                  <a:moveTo>
                    <a:pt x="43200" y="21600"/>
                  </a:moveTo>
                  <a:cubicBezTo>
                    <a:pt x="43200" y="33529"/>
                    <a:pt x="33529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0" y="9670"/>
                    <a:pt x="9670" y="0"/>
                    <a:pt x="21600" y="0"/>
                  </a:cubicBezTo>
                  <a:cubicBezTo>
                    <a:pt x="33529" y="-1"/>
                    <a:pt x="43199" y="9670"/>
                    <a:pt x="43200" y="21599"/>
                  </a:cubicBezTo>
                </a:path>
                <a:path w="43200" h="43200" stroke="0" extrusionOk="0">
                  <a:moveTo>
                    <a:pt x="43200" y="21600"/>
                  </a:moveTo>
                  <a:cubicBezTo>
                    <a:pt x="43200" y="33529"/>
                    <a:pt x="33529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0" y="9670"/>
                    <a:pt x="9670" y="0"/>
                    <a:pt x="21600" y="0"/>
                  </a:cubicBezTo>
                  <a:cubicBezTo>
                    <a:pt x="33529" y="-1"/>
                    <a:pt x="43199" y="9670"/>
                    <a:pt x="43200" y="21599"/>
                  </a:cubicBezTo>
                  <a:lnTo>
                    <a:pt x="21600" y="21600"/>
                  </a:lnTo>
                  <a:close/>
                </a:path>
              </a:pathLst>
            </a:cu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Rectangle 1047"/>
            <p:cNvSpPr>
              <a:spLocks noChangeArrowheads="1"/>
            </p:cNvSpPr>
            <p:nvPr/>
          </p:nvSpPr>
          <p:spPr bwMode="auto">
            <a:xfrm rot="16200000">
              <a:off x="-345305" y="2329523"/>
              <a:ext cx="1659109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%</a:t>
              </a:r>
              <a:r>
                <a:rPr lang="en-US" altLang="ja-JP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D-1</a:t>
              </a:r>
              <a:r>
                <a:rPr lang="en-US" altLang="ja-JP" sz="1100" baseline="30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altLang="ja-JP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s in CD4</a:t>
              </a:r>
              <a:r>
                <a:rPr lang="en-US" altLang="ja-JP" sz="1100" baseline="30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ja-JP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cells</a:t>
              </a:r>
              <a:endParaRPr lang="en-US" altLang="ja-JP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Line 1048"/>
            <p:cNvSpPr>
              <a:spLocks noChangeShapeType="1"/>
            </p:cNvSpPr>
            <p:nvPr/>
          </p:nvSpPr>
          <p:spPr bwMode="auto">
            <a:xfrm>
              <a:off x="895301" y="3461079"/>
              <a:ext cx="1512000" cy="158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Rectangle 1050"/>
            <p:cNvSpPr>
              <a:spLocks noChangeArrowheads="1"/>
            </p:cNvSpPr>
            <p:nvPr/>
          </p:nvSpPr>
          <p:spPr bwMode="auto">
            <a:xfrm>
              <a:off x="1146558" y="3503744"/>
              <a:ext cx="470484" cy="1693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n-</a:t>
              </a:r>
              <a:r>
                <a:rPr lang="en-US" altLang="ja-JP" sz="1100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g</a:t>
              </a:r>
              <a:r>
                <a:rPr lang="en-US" altLang="ja-JP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altLang="ja-JP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Line 1053"/>
            <p:cNvSpPr>
              <a:spLocks noChangeShapeType="1"/>
            </p:cNvSpPr>
            <p:nvPr/>
          </p:nvSpPr>
          <p:spPr bwMode="auto">
            <a:xfrm flipV="1">
              <a:off x="904225" y="1632279"/>
              <a:ext cx="1588" cy="18288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Line 1054"/>
            <p:cNvSpPr>
              <a:spLocks noChangeShapeType="1"/>
            </p:cNvSpPr>
            <p:nvPr/>
          </p:nvSpPr>
          <p:spPr bwMode="auto">
            <a:xfrm flipH="1">
              <a:off x="839739" y="3461079"/>
              <a:ext cx="55563" cy="158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tangle 1055"/>
            <p:cNvSpPr>
              <a:spLocks noChangeArrowheads="1"/>
            </p:cNvSpPr>
            <p:nvPr/>
          </p:nvSpPr>
          <p:spPr bwMode="auto">
            <a:xfrm>
              <a:off x="711327" y="3374325"/>
              <a:ext cx="78548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ja-JP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Line 1058"/>
            <p:cNvSpPr>
              <a:spLocks noChangeShapeType="1"/>
            </p:cNvSpPr>
            <p:nvPr/>
          </p:nvSpPr>
          <p:spPr bwMode="auto">
            <a:xfrm flipH="1">
              <a:off x="846615" y="2938791"/>
              <a:ext cx="55563" cy="158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Rectangle 1059"/>
            <p:cNvSpPr>
              <a:spLocks noChangeArrowheads="1"/>
            </p:cNvSpPr>
            <p:nvPr/>
          </p:nvSpPr>
          <p:spPr bwMode="auto">
            <a:xfrm>
              <a:off x="646974" y="2854152"/>
              <a:ext cx="157094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altLang="ja-JP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Line 1062"/>
            <p:cNvSpPr>
              <a:spLocks noChangeShapeType="1"/>
            </p:cNvSpPr>
            <p:nvPr/>
          </p:nvSpPr>
          <p:spPr bwMode="auto">
            <a:xfrm flipH="1">
              <a:off x="846615" y="2418091"/>
              <a:ext cx="55563" cy="158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Rectangle 1063"/>
            <p:cNvSpPr>
              <a:spLocks noChangeArrowheads="1"/>
            </p:cNvSpPr>
            <p:nvPr/>
          </p:nvSpPr>
          <p:spPr bwMode="auto">
            <a:xfrm>
              <a:off x="646974" y="2335039"/>
              <a:ext cx="157094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altLang="ja-JP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Line 1066"/>
            <p:cNvSpPr>
              <a:spLocks noChangeShapeType="1"/>
            </p:cNvSpPr>
            <p:nvPr/>
          </p:nvSpPr>
          <p:spPr bwMode="auto">
            <a:xfrm flipH="1">
              <a:off x="846615" y="1894216"/>
              <a:ext cx="55563" cy="158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Rectangle 1067"/>
            <p:cNvSpPr>
              <a:spLocks noChangeArrowheads="1"/>
            </p:cNvSpPr>
            <p:nvPr/>
          </p:nvSpPr>
          <p:spPr bwMode="auto">
            <a:xfrm>
              <a:off x="646974" y="1816503"/>
              <a:ext cx="157094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en-US" altLang="ja-JP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右大かっこ 28"/>
            <p:cNvSpPr/>
            <p:nvPr/>
          </p:nvSpPr>
          <p:spPr>
            <a:xfrm rot="16200000">
              <a:off x="1678359" y="1364692"/>
              <a:ext cx="108000" cy="658018"/>
            </a:xfrm>
            <a:prstGeom prst="righ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1620300" y="1393479"/>
              <a:ext cx="3481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＊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Rectangle 1052"/>
            <p:cNvSpPr>
              <a:spLocks noChangeArrowheads="1"/>
            </p:cNvSpPr>
            <p:nvPr/>
          </p:nvSpPr>
          <p:spPr bwMode="auto">
            <a:xfrm>
              <a:off x="1804561" y="3503111"/>
              <a:ext cx="495328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BZ-</a:t>
              </a:r>
              <a:r>
                <a:rPr lang="en-US" altLang="ja-JP" sz="1100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g</a:t>
              </a:r>
              <a:endParaRPr lang="en-US" altLang="ja-JP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7" name="正方形/長方形 256"/>
          <p:cNvSpPr/>
          <p:nvPr/>
        </p:nvSpPr>
        <p:spPr>
          <a:xfrm>
            <a:off x="693329" y="7667806"/>
            <a:ext cx="5615324" cy="338495"/>
          </a:xfrm>
          <a:prstGeom prst="rect">
            <a:avLst/>
          </a:prstGeom>
        </p:spPr>
        <p:txBody>
          <a:bodyPr wrap="square" lIns="91422" tIns="45711" rIns="91422" bIns="45711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9 Fig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PD-1 expression on CD4</a:t>
            </a:r>
            <a:r>
              <a:rPr lang="en-US" altLang="ja-JP" sz="1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 T cells of HBZ-</a:t>
            </a:r>
            <a:r>
              <a:rPr lang="en-US" altLang="ja-JP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 mice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グループ化 1"/>
          <p:cNvGrpSpPr/>
          <p:nvPr/>
        </p:nvGrpSpPr>
        <p:grpSpPr>
          <a:xfrm>
            <a:off x="1341251" y="2124153"/>
            <a:ext cx="3800762" cy="1992072"/>
            <a:chOff x="1187094" y="903288"/>
            <a:chExt cx="3801642" cy="1992418"/>
          </a:xfrm>
        </p:grpSpPr>
        <p:sp>
          <p:nvSpPr>
            <p:cNvPr id="451" name="Rectangle 6"/>
            <p:cNvSpPr>
              <a:spLocks noChangeArrowheads="1"/>
            </p:cNvSpPr>
            <p:nvPr/>
          </p:nvSpPr>
          <p:spPr bwMode="auto">
            <a:xfrm>
              <a:off x="1676684" y="904467"/>
              <a:ext cx="1440000" cy="1438275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29" name="Freeform 85"/>
            <p:cNvSpPr>
              <a:spLocks/>
            </p:cNvSpPr>
            <p:nvPr/>
          </p:nvSpPr>
          <p:spPr bwMode="auto">
            <a:xfrm>
              <a:off x="1687798" y="987811"/>
              <a:ext cx="1415256" cy="1343819"/>
            </a:xfrm>
            <a:custGeom>
              <a:avLst/>
              <a:gdLst>
                <a:gd name="T0" fmla="*/ 14 w 1783"/>
                <a:gd name="T1" fmla="*/ 1630 h 1693"/>
                <a:gd name="T2" fmla="*/ 49 w 1783"/>
                <a:gd name="T3" fmla="*/ 1693 h 1693"/>
                <a:gd name="T4" fmla="*/ 84 w 1783"/>
                <a:gd name="T5" fmla="*/ 1693 h 1693"/>
                <a:gd name="T6" fmla="*/ 119 w 1783"/>
                <a:gd name="T7" fmla="*/ 1693 h 1693"/>
                <a:gd name="T8" fmla="*/ 154 w 1783"/>
                <a:gd name="T9" fmla="*/ 1665 h 1693"/>
                <a:gd name="T10" fmla="*/ 189 w 1783"/>
                <a:gd name="T11" fmla="*/ 1693 h 1693"/>
                <a:gd name="T12" fmla="*/ 224 w 1783"/>
                <a:gd name="T13" fmla="*/ 1665 h 1693"/>
                <a:gd name="T14" fmla="*/ 258 w 1783"/>
                <a:gd name="T15" fmla="*/ 1686 h 1693"/>
                <a:gd name="T16" fmla="*/ 293 w 1783"/>
                <a:gd name="T17" fmla="*/ 1644 h 1693"/>
                <a:gd name="T18" fmla="*/ 328 w 1783"/>
                <a:gd name="T19" fmla="*/ 1672 h 1693"/>
                <a:gd name="T20" fmla="*/ 363 w 1783"/>
                <a:gd name="T21" fmla="*/ 1679 h 1693"/>
                <a:gd name="T22" fmla="*/ 398 w 1783"/>
                <a:gd name="T23" fmla="*/ 1644 h 1693"/>
                <a:gd name="T24" fmla="*/ 433 w 1783"/>
                <a:gd name="T25" fmla="*/ 1623 h 1693"/>
                <a:gd name="T26" fmla="*/ 468 w 1783"/>
                <a:gd name="T27" fmla="*/ 1581 h 1693"/>
                <a:gd name="T28" fmla="*/ 503 w 1783"/>
                <a:gd name="T29" fmla="*/ 1588 h 1693"/>
                <a:gd name="T30" fmla="*/ 538 w 1783"/>
                <a:gd name="T31" fmla="*/ 1490 h 1693"/>
                <a:gd name="T32" fmla="*/ 573 w 1783"/>
                <a:gd name="T33" fmla="*/ 1476 h 1693"/>
                <a:gd name="T34" fmla="*/ 608 w 1783"/>
                <a:gd name="T35" fmla="*/ 1371 h 1693"/>
                <a:gd name="T36" fmla="*/ 643 w 1783"/>
                <a:gd name="T37" fmla="*/ 1294 h 1693"/>
                <a:gd name="T38" fmla="*/ 678 w 1783"/>
                <a:gd name="T39" fmla="*/ 1301 h 1693"/>
                <a:gd name="T40" fmla="*/ 713 w 1783"/>
                <a:gd name="T41" fmla="*/ 874 h 1693"/>
                <a:gd name="T42" fmla="*/ 748 w 1783"/>
                <a:gd name="T43" fmla="*/ 755 h 1693"/>
                <a:gd name="T44" fmla="*/ 783 w 1783"/>
                <a:gd name="T45" fmla="*/ 448 h 1693"/>
                <a:gd name="T46" fmla="*/ 818 w 1783"/>
                <a:gd name="T47" fmla="*/ 189 h 1693"/>
                <a:gd name="T48" fmla="*/ 853 w 1783"/>
                <a:gd name="T49" fmla="*/ 0 h 1693"/>
                <a:gd name="T50" fmla="*/ 888 w 1783"/>
                <a:gd name="T51" fmla="*/ 161 h 1693"/>
                <a:gd name="T52" fmla="*/ 923 w 1783"/>
                <a:gd name="T53" fmla="*/ 518 h 1693"/>
                <a:gd name="T54" fmla="*/ 958 w 1783"/>
                <a:gd name="T55" fmla="*/ 965 h 1693"/>
                <a:gd name="T56" fmla="*/ 993 w 1783"/>
                <a:gd name="T57" fmla="*/ 1308 h 1693"/>
                <a:gd name="T58" fmla="*/ 1028 w 1783"/>
                <a:gd name="T59" fmla="*/ 1546 h 1693"/>
                <a:gd name="T60" fmla="*/ 1063 w 1783"/>
                <a:gd name="T61" fmla="*/ 1637 h 1693"/>
                <a:gd name="T62" fmla="*/ 1098 w 1783"/>
                <a:gd name="T63" fmla="*/ 1672 h 1693"/>
                <a:gd name="T64" fmla="*/ 1133 w 1783"/>
                <a:gd name="T65" fmla="*/ 1679 h 1693"/>
                <a:gd name="T66" fmla="*/ 1168 w 1783"/>
                <a:gd name="T67" fmla="*/ 1686 h 1693"/>
                <a:gd name="T68" fmla="*/ 1203 w 1783"/>
                <a:gd name="T69" fmla="*/ 1686 h 1693"/>
                <a:gd name="T70" fmla="*/ 1238 w 1783"/>
                <a:gd name="T71" fmla="*/ 1686 h 1693"/>
                <a:gd name="T72" fmla="*/ 1273 w 1783"/>
                <a:gd name="T73" fmla="*/ 1686 h 1693"/>
                <a:gd name="T74" fmla="*/ 1308 w 1783"/>
                <a:gd name="T75" fmla="*/ 1693 h 1693"/>
                <a:gd name="T76" fmla="*/ 1343 w 1783"/>
                <a:gd name="T77" fmla="*/ 1693 h 1693"/>
                <a:gd name="T78" fmla="*/ 1378 w 1783"/>
                <a:gd name="T79" fmla="*/ 1693 h 1693"/>
                <a:gd name="T80" fmla="*/ 1413 w 1783"/>
                <a:gd name="T81" fmla="*/ 1693 h 1693"/>
                <a:gd name="T82" fmla="*/ 1448 w 1783"/>
                <a:gd name="T83" fmla="*/ 1693 h 1693"/>
                <a:gd name="T84" fmla="*/ 1482 w 1783"/>
                <a:gd name="T85" fmla="*/ 1693 h 1693"/>
                <a:gd name="T86" fmla="*/ 1517 w 1783"/>
                <a:gd name="T87" fmla="*/ 1693 h 1693"/>
                <a:gd name="T88" fmla="*/ 1552 w 1783"/>
                <a:gd name="T89" fmla="*/ 1693 h 1693"/>
                <a:gd name="T90" fmla="*/ 1587 w 1783"/>
                <a:gd name="T91" fmla="*/ 1693 h 1693"/>
                <a:gd name="T92" fmla="*/ 1622 w 1783"/>
                <a:gd name="T93" fmla="*/ 1693 h 1693"/>
                <a:gd name="T94" fmla="*/ 1657 w 1783"/>
                <a:gd name="T95" fmla="*/ 1693 h 1693"/>
                <a:gd name="T96" fmla="*/ 1692 w 1783"/>
                <a:gd name="T97" fmla="*/ 1693 h 1693"/>
                <a:gd name="T98" fmla="*/ 1727 w 1783"/>
                <a:gd name="T99" fmla="*/ 1693 h 1693"/>
                <a:gd name="T100" fmla="*/ 1762 w 1783"/>
                <a:gd name="T101" fmla="*/ 1693 h 16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783" h="1693">
                  <a:moveTo>
                    <a:pt x="0" y="1693"/>
                  </a:moveTo>
                  <a:lnTo>
                    <a:pt x="0" y="469"/>
                  </a:lnTo>
                  <a:lnTo>
                    <a:pt x="0" y="979"/>
                  </a:lnTo>
                  <a:lnTo>
                    <a:pt x="7" y="1441"/>
                  </a:lnTo>
                  <a:lnTo>
                    <a:pt x="14" y="1630"/>
                  </a:lnTo>
                  <a:lnTo>
                    <a:pt x="21" y="1679"/>
                  </a:lnTo>
                  <a:lnTo>
                    <a:pt x="28" y="1686"/>
                  </a:lnTo>
                  <a:lnTo>
                    <a:pt x="35" y="1693"/>
                  </a:lnTo>
                  <a:lnTo>
                    <a:pt x="42" y="1693"/>
                  </a:lnTo>
                  <a:lnTo>
                    <a:pt x="49" y="1693"/>
                  </a:lnTo>
                  <a:lnTo>
                    <a:pt x="56" y="1693"/>
                  </a:lnTo>
                  <a:lnTo>
                    <a:pt x="63" y="1693"/>
                  </a:lnTo>
                  <a:lnTo>
                    <a:pt x="70" y="1693"/>
                  </a:lnTo>
                  <a:lnTo>
                    <a:pt x="77" y="1693"/>
                  </a:lnTo>
                  <a:lnTo>
                    <a:pt x="84" y="1693"/>
                  </a:lnTo>
                  <a:lnTo>
                    <a:pt x="91" y="1693"/>
                  </a:lnTo>
                  <a:lnTo>
                    <a:pt x="98" y="1693"/>
                  </a:lnTo>
                  <a:lnTo>
                    <a:pt x="105" y="1693"/>
                  </a:lnTo>
                  <a:lnTo>
                    <a:pt x="112" y="1693"/>
                  </a:lnTo>
                  <a:lnTo>
                    <a:pt x="119" y="1693"/>
                  </a:lnTo>
                  <a:lnTo>
                    <a:pt x="126" y="1693"/>
                  </a:lnTo>
                  <a:lnTo>
                    <a:pt x="133" y="1693"/>
                  </a:lnTo>
                  <a:lnTo>
                    <a:pt x="140" y="1679"/>
                  </a:lnTo>
                  <a:lnTo>
                    <a:pt x="147" y="1672"/>
                  </a:lnTo>
                  <a:lnTo>
                    <a:pt x="154" y="1665"/>
                  </a:lnTo>
                  <a:lnTo>
                    <a:pt x="161" y="1672"/>
                  </a:lnTo>
                  <a:lnTo>
                    <a:pt x="168" y="1679"/>
                  </a:lnTo>
                  <a:lnTo>
                    <a:pt x="175" y="1693"/>
                  </a:lnTo>
                  <a:lnTo>
                    <a:pt x="182" y="1693"/>
                  </a:lnTo>
                  <a:lnTo>
                    <a:pt x="189" y="1693"/>
                  </a:lnTo>
                  <a:lnTo>
                    <a:pt x="196" y="1693"/>
                  </a:lnTo>
                  <a:lnTo>
                    <a:pt x="203" y="1693"/>
                  </a:lnTo>
                  <a:lnTo>
                    <a:pt x="210" y="1693"/>
                  </a:lnTo>
                  <a:lnTo>
                    <a:pt x="217" y="1686"/>
                  </a:lnTo>
                  <a:lnTo>
                    <a:pt x="224" y="1665"/>
                  </a:lnTo>
                  <a:lnTo>
                    <a:pt x="231" y="1630"/>
                  </a:lnTo>
                  <a:lnTo>
                    <a:pt x="238" y="1609"/>
                  </a:lnTo>
                  <a:lnTo>
                    <a:pt x="245" y="1630"/>
                  </a:lnTo>
                  <a:lnTo>
                    <a:pt x="252" y="1665"/>
                  </a:lnTo>
                  <a:lnTo>
                    <a:pt x="258" y="1686"/>
                  </a:lnTo>
                  <a:lnTo>
                    <a:pt x="265" y="1693"/>
                  </a:lnTo>
                  <a:lnTo>
                    <a:pt x="272" y="1693"/>
                  </a:lnTo>
                  <a:lnTo>
                    <a:pt x="279" y="1686"/>
                  </a:lnTo>
                  <a:lnTo>
                    <a:pt x="286" y="1672"/>
                  </a:lnTo>
                  <a:lnTo>
                    <a:pt x="293" y="1644"/>
                  </a:lnTo>
                  <a:lnTo>
                    <a:pt x="300" y="1630"/>
                  </a:lnTo>
                  <a:lnTo>
                    <a:pt x="307" y="1644"/>
                  </a:lnTo>
                  <a:lnTo>
                    <a:pt x="314" y="1672"/>
                  </a:lnTo>
                  <a:lnTo>
                    <a:pt x="321" y="1679"/>
                  </a:lnTo>
                  <a:lnTo>
                    <a:pt x="328" y="1672"/>
                  </a:lnTo>
                  <a:lnTo>
                    <a:pt x="335" y="1644"/>
                  </a:lnTo>
                  <a:lnTo>
                    <a:pt x="342" y="1637"/>
                  </a:lnTo>
                  <a:lnTo>
                    <a:pt x="349" y="1644"/>
                  </a:lnTo>
                  <a:lnTo>
                    <a:pt x="356" y="1672"/>
                  </a:lnTo>
                  <a:lnTo>
                    <a:pt x="363" y="1679"/>
                  </a:lnTo>
                  <a:lnTo>
                    <a:pt x="370" y="1672"/>
                  </a:lnTo>
                  <a:lnTo>
                    <a:pt x="377" y="1644"/>
                  </a:lnTo>
                  <a:lnTo>
                    <a:pt x="384" y="1630"/>
                  </a:lnTo>
                  <a:lnTo>
                    <a:pt x="391" y="1637"/>
                  </a:lnTo>
                  <a:lnTo>
                    <a:pt x="398" y="1644"/>
                  </a:lnTo>
                  <a:lnTo>
                    <a:pt x="405" y="1616"/>
                  </a:lnTo>
                  <a:lnTo>
                    <a:pt x="412" y="1602"/>
                  </a:lnTo>
                  <a:lnTo>
                    <a:pt x="419" y="1616"/>
                  </a:lnTo>
                  <a:lnTo>
                    <a:pt x="426" y="1637"/>
                  </a:lnTo>
                  <a:lnTo>
                    <a:pt x="433" y="1623"/>
                  </a:lnTo>
                  <a:lnTo>
                    <a:pt x="440" y="1609"/>
                  </a:lnTo>
                  <a:lnTo>
                    <a:pt x="447" y="1623"/>
                  </a:lnTo>
                  <a:lnTo>
                    <a:pt x="454" y="1630"/>
                  </a:lnTo>
                  <a:lnTo>
                    <a:pt x="461" y="1609"/>
                  </a:lnTo>
                  <a:lnTo>
                    <a:pt x="468" y="1581"/>
                  </a:lnTo>
                  <a:lnTo>
                    <a:pt x="475" y="1581"/>
                  </a:lnTo>
                  <a:lnTo>
                    <a:pt x="482" y="1588"/>
                  </a:lnTo>
                  <a:lnTo>
                    <a:pt x="489" y="1581"/>
                  </a:lnTo>
                  <a:lnTo>
                    <a:pt x="496" y="1588"/>
                  </a:lnTo>
                  <a:lnTo>
                    <a:pt x="503" y="1588"/>
                  </a:lnTo>
                  <a:lnTo>
                    <a:pt x="510" y="1588"/>
                  </a:lnTo>
                  <a:lnTo>
                    <a:pt x="517" y="1588"/>
                  </a:lnTo>
                  <a:lnTo>
                    <a:pt x="524" y="1560"/>
                  </a:lnTo>
                  <a:lnTo>
                    <a:pt x="531" y="1511"/>
                  </a:lnTo>
                  <a:lnTo>
                    <a:pt x="538" y="1490"/>
                  </a:lnTo>
                  <a:lnTo>
                    <a:pt x="545" y="1483"/>
                  </a:lnTo>
                  <a:lnTo>
                    <a:pt x="552" y="1497"/>
                  </a:lnTo>
                  <a:lnTo>
                    <a:pt x="559" y="1504"/>
                  </a:lnTo>
                  <a:lnTo>
                    <a:pt x="566" y="1490"/>
                  </a:lnTo>
                  <a:lnTo>
                    <a:pt x="573" y="1476"/>
                  </a:lnTo>
                  <a:lnTo>
                    <a:pt x="580" y="1476"/>
                  </a:lnTo>
                  <a:lnTo>
                    <a:pt x="587" y="1476"/>
                  </a:lnTo>
                  <a:lnTo>
                    <a:pt x="594" y="1462"/>
                  </a:lnTo>
                  <a:lnTo>
                    <a:pt x="601" y="1427"/>
                  </a:lnTo>
                  <a:lnTo>
                    <a:pt x="608" y="1371"/>
                  </a:lnTo>
                  <a:lnTo>
                    <a:pt x="615" y="1287"/>
                  </a:lnTo>
                  <a:lnTo>
                    <a:pt x="622" y="1280"/>
                  </a:lnTo>
                  <a:lnTo>
                    <a:pt x="629" y="1336"/>
                  </a:lnTo>
                  <a:lnTo>
                    <a:pt x="636" y="1315"/>
                  </a:lnTo>
                  <a:lnTo>
                    <a:pt x="643" y="1294"/>
                  </a:lnTo>
                  <a:lnTo>
                    <a:pt x="650" y="1315"/>
                  </a:lnTo>
                  <a:lnTo>
                    <a:pt x="657" y="1252"/>
                  </a:lnTo>
                  <a:lnTo>
                    <a:pt x="664" y="1189"/>
                  </a:lnTo>
                  <a:lnTo>
                    <a:pt x="671" y="1252"/>
                  </a:lnTo>
                  <a:lnTo>
                    <a:pt x="678" y="1301"/>
                  </a:lnTo>
                  <a:lnTo>
                    <a:pt x="685" y="1210"/>
                  </a:lnTo>
                  <a:lnTo>
                    <a:pt x="692" y="1077"/>
                  </a:lnTo>
                  <a:lnTo>
                    <a:pt x="699" y="965"/>
                  </a:lnTo>
                  <a:lnTo>
                    <a:pt x="706" y="881"/>
                  </a:lnTo>
                  <a:lnTo>
                    <a:pt x="713" y="874"/>
                  </a:lnTo>
                  <a:lnTo>
                    <a:pt x="720" y="902"/>
                  </a:lnTo>
                  <a:lnTo>
                    <a:pt x="727" y="902"/>
                  </a:lnTo>
                  <a:lnTo>
                    <a:pt x="734" y="874"/>
                  </a:lnTo>
                  <a:lnTo>
                    <a:pt x="741" y="839"/>
                  </a:lnTo>
                  <a:lnTo>
                    <a:pt x="748" y="755"/>
                  </a:lnTo>
                  <a:lnTo>
                    <a:pt x="755" y="629"/>
                  </a:lnTo>
                  <a:lnTo>
                    <a:pt x="762" y="538"/>
                  </a:lnTo>
                  <a:lnTo>
                    <a:pt x="769" y="462"/>
                  </a:lnTo>
                  <a:lnTo>
                    <a:pt x="776" y="455"/>
                  </a:lnTo>
                  <a:lnTo>
                    <a:pt x="783" y="448"/>
                  </a:lnTo>
                  <a:lnTo>
                    <a:pt x="790" y="350"/>
                  </a:lnTo>
                  <a:lnTo>
                    <a:pt x="797" y="322"/>
                  </a:lnTo>
                  <a:lnTo>
                    <a:pt x="804" y="322"/>
                  </a:lnTo>
                  <a:lnTo>
                    <a:pt x="811" y="238"/>
                  </a:lnTo>
                  <a:lnTo>
                    <a:pt x="818" y="189"/>
                  </a:lnTo>
                  <a:lnTo>
                    <a:pt x="825" y="126"/>
                  </a:lnTo>
                  <a:lnTo>
                    <a:pt x="832" y="63"/>
                  </a:lnTo>
                  <a:lnTo>
                    <a:pt x="839" y="35"/>
                  </a:lnTo>
                  <a:lnTo>
                    <a:pt x="846" y="0"/>
                  </a:lnTo>
                  <a:lnTo>
                    <a:pt x="853" y="0"/>
                  </a:lnTo>
                  <a:lnTo>
                    <a:pt x="860" y="7"/>
                  </a:lnTo>
                  <a:lnTo>
                    <a:pt x="867" y="14"/>
                  </a:lnTo>
                  <a:lnTo>
                    <a:pt x="874" y="56"/>
                  </a:lnTo>
                  <a:lnTo>
                    <a:pt x="881" y="112"/>
                  </a:lnTo>
                  <a:lnTo>
                    <a:pt x="888" y="161"/>
                  </a:lnTo>
                  <a:lnTo>
                    <a:pt x="895" y="161"/>
                  </a:lnTo>
                  <a:lnTo>
                    <a:pt x="902" y="63"/>
                  </a:lnTo>
                  <a:lnTo>
                    <a:pt x="909" y="56"/>
                  </a:lnTo>
                  <a:lnTo>
                    <a:pt x="916" y="315"/>
                  </a:lnTo>
                  <a:lnTo>
                    <a:pt x="923" y="518"/>
                  </a:lnTo>
                  <a:lnTo>
                    <a:pt x="930" y="580"/>
                  </a:lnTo>
                  <a:lnTo>
                    <a:pt x="937" y="525"/>
                  </a:lnTo>
                  <a:lnTo>
                    <a:pt x="944" y="629"/>
                  </a:lnTo>
                  <a:lnTo>
                    <a:pt x="951" y="846"/>
                  </a:lnTo>
                  <a:lnTo>
                    <a:pt x="958" y="965"/>
                  </a:lnTo>
                  <a:lnTo>
                    <a:pt x="965" y="1014"/>
                  </a:lnTo>
                  <a:lnTo>
                    <a:pt x="972" y="1084"/>
                  </a:lnTo>
                  <a:lnTo>
                    <a:pt x="979" y="1147"/>
                  </a:lnTo>
                  <a:lnTo>
                    <a:pt x="986" y="1210"/>
                  </a:lnTo>
                  <a:lnTo>
                    <a:pt x="993" y="1308"/>
                  </a:lnTo>
                  <a:lnTo>
                    <a:pt x="1000" y="1399"/>
                  </a:lnTo>
                  <a:lnTo>
                    <a:pt x="1007" y="1455"/>
                  </a:lnTo>
                  <a:lnTo>
                    <a:pt x="1014" y="1497"/>
                  </a:lnTo>
                  <a:lnTo>
                    <a:pt x="1021" y="1525"/>
                  </a:lnTo>
                  <a:lnTo>
                    <a:pt x="1028" y="1546"/>
                  </a:lnTo>
                  <a:lnTo>
                    <a:pt x="1035" y="1574"/>
                  </a:lnTo>
                  <a:lnTo>
                    <a:pt x="1042" y="1602"/>
                  </a:lnTo>
                  <a:lnTo>
                    <a:pt x="1049" y="1623"/>
                  </a:lnTo>
                  <a:lnTo>
                    <a:pt x="1056" y="1630"/>
                  </a:lnTo>
                  <a:lnTo>
                    <a:pt x="1063" y="1637"/>
                  </a:lnTo>
                  <a:lnTo>
                    <a:pt x="1070" y="1644"/>
                  </a:lnTo>
                  <a:lnTo>
                    <a:pt x="1077" y="1651"/>
                  </a:lnTo>
                  <a:lnTo>
                    <a:pt x="1084" y="1665"/>
                  </a:lnTo>
                  <a:lnTo>
                    <a:pt x="1091" y="1672"/>
                  </a:lnTo>
                  <a:lnTo>
                    <a:pt x="1098" y="1672"/>
                  </a:lnTo>
                  <a:lnTo>
                    <a:pt x="1105" y="1672"/>
                  </a:lnTo>
                  <a:lnTo>
                    <a:pt x="1112" y="1679"/>
                  </a:lnTo>
                  <a:lnTo>
                    <a:pt x="1119" y="1679"/>
                  </a:lnTo>
                  <a:lnTo>
                    <a:pt x="1126" y="1679"/>
                  </a:lnTo>
                  <a:lnTo>
                    <a:pt x="1133" y="1679"/>
                  </a:lnTo>
                  <a:lnTo>
                    <a:pt x="1140" y="1679"/>
                  </a:lnTo>
                  <a:lnTo>
                    <a:pt x="1147" y="1679"/>
                  </a:lnTo>
                  <a:lnTo>
                    <a:pt x="1154" y="1679"/>
                  </a:lnTo>
                  <a:lnTo>
                    <a:pt x="1161" y="1679"/>
                  </a:lnTo>
                  <a:lnTo>
                    <a:pt x="1168" y="1686"/>
                  </a:lnTo>
                  <a:lnTo>
                    <a:pt x="1175" y="1686"/>
                  </a:lnTo>
                  <a:lnTo>
                    <a:pt x="1182" y="1686"/>
                  </a:lnTo>
                  <a:lnTo>
                    <a:pt x="1189" y="1686"/>
                  </a:lnTo>
                  <a:lnTo>
                    <a:pt x="1196" y="1686"/>
                  </a:lnTo>
                  <a:lnTo>
                    <a:pt x="1203" y="1686"/>
                  </a:lnTo>
                  <a:lnTo>
                    <a:pt x="1210" y="1686"/>
                  </a:lnTo>
                  <a:lnTo>
                    <a:pt x="1217" y="1693"/>
                  </a:lnTo>
                  <a:lnTo>
                    <a:pt x="1224" y="1693"/>
                  </a:lnTo>
                  <a:lnTo>
                    <a:pt x="1231" y="1693"/>
                  </a:lnTo>
                  <a:lnTo>
                    <a:pt x="1238" y="1686"/>
                  </a:lnTo>
                  <a:lnTo>
                    <a:pt x="1245" y="1686"/>
                  </a:lnTo>
                  <a:lnTo>
                    <a:pt x="1252" y="1686"/>
                  </a:lnTo>
                  <a:lnTo>
                    <a:pt x="1259" y="1686"/>
                  </a:lnTo>
                  <a:lnTo>
                    <a:pt x="1266" y="1686"/>
                  </a:lnTo>
                  <a:lnTo>
                    <a:pt x="1273" y="1686"/>
                  </a:lnTo>
                  <a:lnTo>
                    <a:pt x="1280" y="1686"/>
                  </a:lnTo>
                  <a:lnTo>
                    <a:pt x="1287" y="1686"/>
                  </a:lnTo>
                  <a:lnTo>
                    <a:pt x="1294" y="1693"/>
                  </a:lnTo>
                  <a:lnTo>
                    <a:pt x="1301" y="1693"/>
                  </a:lnTo>
                  <a:lnTo>
                    <a:pt x="1308" y="1693"/>
                  </a:lnTo>
                  <a:lnTo>
                    <a:pt x="1315" y="1693"/>
                  </a:lnTo>
                  <a:lnTo>
                    <a:pt x="1322" y="1693"/>
                  </a:lnTo>
                  <a:lnTo>
                    <a:pt x="1329" y="1693"/>
                  </a:lnTo>
                  <a:lnTo>
                    <a:pt x="1336" y="1693"/>
                  </a:lnTo>
                  <a:lnTo>
                    <a:pt x="1343" y="1693"/>
                  </a:lnTo>
                  <a:lnTo>
                    <a:pt x="1350" y="1693"/>
                  </a:lnTo>
                  <a:lnTo>
                    <a:pt x="1357" y="1693"/>
                  </a:lnTo>
                  <a:lnTo>
                    <a:pt x="1364" y="1693"/>
                  </a:lnTo>
                  <a:lnTo>
                    <a:pt x="1371" y="1693"/>
                  </a:lnTo>
                  <a:lnTo>
                    <a:pt x="1378" y="1693"/>
                  </a:lnTo>
                  <a:lnTo>
                    <a:pt x="1385" y="1693"/>
                  </a:lnTo>
                  <a:lnTo>
                    <a:pt x="1392" y="1693"/>
                  </a:lnTo>
                  <a:lnTo>
                    <a:pt x="1399" y="1693"/>
                  </a:lnTo>
                  <a:lnTo>
                    <a:pt x="1406" y="1693"/>
                  </a:lnTo>
                  <a:lnTo>
                    <a:pt x="1413" y="1693"/>
                  </a:lnTo>
                  <a:lnTo>
                    <a:pt x="1420" y="1693"/>
                  </a:lnTo>
                  <a:lnTo>
                    <a:pt x="1427" y="1693"/>
                  </a:lnTo>
                  <a:lnTo>
                    <a:pt x="1434" y="1693"/>
                  </a:lnTo>
                  <a:lnTo>
                    <a:pt x="1441" y="1693"/>
                  </a:lnTo>
                  <a:lnTo>
                    <a:pt x="1448" y="1693"/>
                  </a:lnTo>
                  <a:lnTo>
                    <a:pt x="1455" y="1693"/>
                  </a:lnTo>
                  <a:lnTo>
                    <a:pt x="1462" y="1693"/>
                  </a:lnTo>
                  <a:lnTo>
                    <a:pt x="1469" y="1693"/>
                  </a:lnTo>
                  <a:lnTo>
                    <a:pt x="1476" y="1693"/>
                  </a:lnTo>
                  <a:lnTo>
                    <a:pt x="1482" y="1693"/>
                  </a:lnTo>
                  <a:lnTo>
                    <a:pt x="1489" y="1693"/>
                  </a:lnTo>
                  <a:lnTo>
                    <a:pt x="1496" y="1693"/>
                  </a:lnTo>
                  <a:lnTo>
                    <a:pt x="1503" y="1693"/>
                  </a:lnTo>
                  <a:lnTo>
                    <a:pt x="1510" y="1693"/>
                  </a:lnTo>
                  <a:lnTo>
                    <a:pt x="1517" y="1693"/>
                  </a:lnTo>
                  <a:lnTo>
                    <a:pt x="1524" y="1693"/>
                  </a:lnTo>
                  <a:lnTo>
                    <a:pt x="1531" y="1693"/>
                  </a:lnTo>
                  <a:lnTo>
                    <a:pt x="1538" y="1693"/>
                  </a:lnTo>
                  <a:lnTo>
                    <a:pt x="1545" y="1693"/>
                  </a:lnTo>
                  <a:lnTo>
                    <a:pt x="1552" y="1693"/>
                  </a:lnTo>
                  <a:lnTo>
                    <a:pt x="1559" y="1693"/>
                  </a:lnTo>
                  <a:lnTo>
                    <a:pt x="1566" y="1693"/>
                  </a:lnTo>
                  <a:lnTo>
                    <a:pt x="1573" y="1693"/>
                  </a:lnTo>
                  <a:lnTo>
                    <a:pt x="1580" y="1693"/>
                  </a:lnTo>
                  <a:lnTo>
                    <a:pt x="1587" y="1693"/>
                  </a:lnTo>
                  <a:lnTo>
                    <a:pt x="1594" y="1693"/>
                  </a:lnTo>
                  <a:lnTo>
                    <a:pt x="1601" y="1693"/>
                  </a:lnTo>
                  <a:lnTo>
                    <a:pt x="1608" y="1693"/>
                  </a:lnTo>
                  <a:lnTo>
                    <a:pt x="1615" y="1693"/>
                  </a:lnTo>
                  <a:lnTo>
                    <a:pt x="1622" y="1693"/>
                  </a:lnTo>
                  <a:lnTo>
                    <a:pt x="1629" y="1693"/>
                  </a:lnTo>
                  <a:lnTo>
                    <a:pt x="1636" y="1693"/>
                  </a:lnTo>
                  <a:lnTo>
                    <a:pt x="1643" y="1693"/>
                  </a:lnTo>
                  <a:lnTo>
                    <a:pt x="1650" y="1693"/>
                  </a:lnTo>
                  <a:lnTo>
                    <a:pt x="1657" y="1693"/>
                  </a:lnTo>
                  <a:lnTo>
                    <a:pt x="1664" y="1693"/>
                  </a:lnTo>
                  <a:lnTo>
                    <a:pt x="1671" y="1693"/>
                  </a:lnTo>
                  <a:lnTo>
                    <a:pt x="1678" y="1693"/>
                  </a:lnTo>
                  <a:lnTo>
                    <a:pt x="1685" y="1693"/>
                  </a:lnTo>
                  <a:lnTo>
                    <a:pt x="1692" y="1693"/>
                  </a:lnTo>
                  <a:lnTo>
                    <a:pt x="1699" y="1693"/>
                  </a:lnTo>
                  <a:lnTo>
                    <a:pt x="1706" y="1693"/>
                  </a:lnTo>
                  <a:lnTo>
                    <a:pt x="1713" y="1693"/>
                  </a:lnTo>
                  <a:lnTo>
                    <a:pt x="1720" y="1693"/>
                  </a:lnTo>
                  <a:lnTo>
                    <a:pt x="1727" y="1693"/>
                  </a:lnTo>
                  <a:lnTo>
                    <a:pt x="1734" y="1693"/>
                  </a:lnTo>
                  <a:lnTo>
                    <a:pt x="1741" y="1693"/>
                  </a:lnTo>
                  <a:lnTo>
                    <a:pt x="1748" y="1693"/>
                  </a:lnTo>
                  <a:lnTo>
                    <a:pt x="1755" y="1693"/>
                  </a:lnTo>
                  <a:lnTo>
                    <a:pt x="1762" y="1693"/>
                  </a:lnTo>
                  <a:lnTo>
                    <a:pt x="1769" y="1693"/>
                  </a:lnTo>
                  <a:lnTo>
                    <a:pt x="1776" y="1693"/>
                  </a:lnTo>
                  <a:lnTo>
                    <a:pt x="1783" y="1693"/>
                  </a:lnTo>
                  <a:lnTo>
                    <a:pt x="0" y="1693"/>
                  </a:lnTo>
                  <a:close/>
                </a:path>
              </a:pathLst>
            </a:custGeom>
            <a:solidFill>
              <a:srgbClr val="CCCCC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31" name="Freeform 86"/>
            <p:cNvSpPr>
              <a:spLocks/>
            </p:cNvSpPr>
            <p:nvPr/>
          </p:nvSpPr>
          <p:spPr bwMode="auto">
            <a:xfrm>
              <a:off x="1687798" y="915582"/>
              <a:ext cx="1409700" cy="1416053"/>
            </a:xfrm>
            <a:custGeom>
              <a:avLst/>
              <a:gdLst>
                <a:gd name="T0" fmla="*/ 14 w 1776"/>
                <a:gd name="T1" fmla="*/ 1686 h 1784"/>
                <a:gd name="T2" fmla="*/ 49 w 1776"/>
                <a:gd name="T3" fmla="*/ 1784 h 1784"/>
                <a:gd name="T4" fmla="*/ 84 w 1776"/>
                <a:gd name="T5" fmla="*/ 1784 h 1784"/>
                <a:gd name="T6" fmla="*/ 119 w 1776"/>
                <a:gd name="T7" fmla="*/ 1784 h 1784"/>
                <a:gd name="T8" fmla="*/ 154 w 1776"/>
                <a:gd name="T9" fmla="*/ 1707 h 1784"/>
                <a:gd name="T10" fmla="*/ 189 w 1776"/>
                <a:gd name="T11" fmla="*/ 1784 h 1784"/>
                <a:gd name="T12" fmla="*/ 224 w 1776"/>
                <a:gd name="T13" fmla="*/ 1749 h 1784"/>
                <a:gd name="T14" fmla="*/ 258 w 1776"/>
                <a:gd name="T15" fmla="*/ 1777 h 1784"/>
                <a:gd name="T16" fmla="*/ 293 w 1776"/>
                <a:gd name="T17" fmla="*/ 1707 h 1784"/>
                <a:gd name="T18" fmla="*/ 328 w 1776"/>
                <a:gd name="T19" fmla="*/ 1756 h 1784"/>
                <a:gd name="T20" fmla="*/ 363 w 1776"/>
                <a:gd name="T21" fmla="*/ 1770 h 1784"/>
                <a:gd name="T22" fmla="*/ 398 w 1776"/>
                <a:gd name="T23" fmla="*/ 1707 h 1784"/>
                <a:gd name="T24" fmla="*/ 433 w 1776"/>
                <a:gd name="T25" fmla="*/ 1700 h 1784"/>
                <a:gd name="T26" fmla="*/ 468 w 1776"/>
                <a:gd name="T27" fmla="*/ 1623 h 1784"/>
                <a:gd name="T28" fmla="*/ 503 w 1776"/>
                <a:gd name="T29" fmla="*/ 1623 h 1784"/>
                <a:gd name="T30" fmla="*/ 538 w 1776"/>
                <a:gd name="T31" fmla="*/ 1532 h 1784"/>
                <a:gd name="T32" fmla="*/ 573 w 1776"/>
                <a:gd name="T33" fmla="*/ 1504 h 1784"/>
                <a:gd name="T34" fmla="*/ 608 w 1776"/>
                <a:gd name="T35" fmla="*/ 1385 h 1784"/>
                <a:gd name="T36" fmla="*/ 643 w 1776"/>
                <a:gd name="T37" fmla="*/ 1336 h 1784"/>
                <a:gd name="T38" fmla="*/ 678 w 1776"/>
                <a:gd name="T39" fmla="*/ 1315 h 1784"/>
                <a:gd name="T40" fmla="*/ 713 w 1776"/>
                <a:gd name="T41" fmla="*/ 923 h 1784"/>
                <a:gd name="T42" fmla="*/ 748 w 1776"/>
                <a:gd name="T43" fmla="*/ 839 h 1784"/>
                <a:gd name="T44" fmla="*/ 783 w 1776"/>
                <a:gd name="T45" fmla="*/ 643 h 1784"/>
                <a:gd name="T46" fmla="*/ 818 w 1776"/>
                <a:gd name="T47" fmla="*/ 448 h 1784"/>
                <a:gd name="T48" fmla="*/ 853 w 1776"/>
                <a:gd name="T49" fmla="*/ 112 h 1784"/>
                <a:gd name="T50" fmla="*/ 888 w 1776"/>
                <a:gd name="T51" fmla="*/ 364 h 1784"/>
                <a:gd name="T52" fmla="*/ 923 w 1776"/>
                <a:gd name="T53" fmla="*/ 609 h 1784"/>
                <a:gd name="T54" fmla="*/ 958 w 1776"/>
                <a:gd name="T55" fmla="*/ 972 h 1784"/>
                <a:gd name="T56" fmla="*/ 993 w 1776"/>
                <a:gd name="T57" fmla="*/ 1245 h 1784"/>
                <a:gd name="T58" fmla="*/ 1028 w 1776"/>
                <a:gd name="T59" fmla="*/ 1385 h 1784"/>
                <a:gd name="T60" fmla="*/ 1063 w 1776"/>
                <a:gd name="T61" fmla="*/ 1490 h 1784"/>
                <a:gd name="T62" fmla="*/ 1098 w 1776"/>
                <a:gd name="T63" fmla="*/ 1574 h 1784"/>
                <a:gd name="T64" fmla="*/ 1133 w 1776"/>
                <a:gd name="T65" fmla="*/ 1644 h 1784"/>
                <a:gd name="T66" fmla="*/ 1168 w 1776"/>
                <a:gd name="T67" fmla="*/ 1637 h 1784"/>
                <a:gd name="T68" fmla="*/ 1203 w 1776"/>
                <a:gd name="T69" fmla="*/ 1630 h 1784"/>
                <a:gd name="T70" fmla="*/ 1238 w 1776"/>
                <a:gd name="T71" fmla="*/ 1637 h 1784"/>
                <a:gd name="T72" fmla="*/ 1273 w 1776"/>
                <a:gd name="T73" fmla="*/ 1658 h 1784"/>
                <a:gd name="T74" fmla="*/ 1308 w 1776"/>
                <a:gd name="T75" fmla="*/ 1672 h 1784"/>
                <a:gd name="T76" fmla="*/ 1343 w 1776"/>
                <a:gd name="T77" fmla="*/ 1679 h 1784"/>
                <a:gd name="T78" fmla="*/ 1378 w 1776"/>
                <a:gd name="T79" fmla="*/ 1672 h 1784"/>
                <a:gd name="T80" fmla="*/ 1413 w 1776"/>
                <a:gd name="T81" fmla="*/ 1686 h 1784"/>
                <a:gd name="T82" fmla="*/ 1448 w 1776"/>
                <a:gd name="T83" fmla="*/ 1714 h 1784"/>
                <a:gd name="T84" fmla="*/ 1482 w 1776"/>
                <a:gd name="T85" fmla="*/ 1721 h 1784"/>
                <a:gd name="T86" fmla="*/ 1517 w 1776"/>
                <a:gd name="T87" fmla="*/ 1735 h 1784"/>
                <a:gd name="T88" fmla="*/ 1552 w 1776"/>
                <a:gd name="T89" fmla="*/ 1749 h 1784"/>
                <a:gd name="T90" fmla="*/ 1587 w 1776"/>
                <a:gd name="T91" fmla="*/ 1763 h 1784"/>
                <a:gd name="T92" fmla="*/ 1622 w 1776"/>
                <a:gd name="T93" fmla="*/ 1756 h 1784"/>
                <a:gd name="T94" fmla="*/ 1657 w 1776"/>
                <a:gd name="T95" fmla="*/ 1770 h 1784"/>
                <a:gd name="T96" fmla="*/ 1692 w 1776"/>
                <a:gd name="T97" fmla="*/ 1777 h 1784"/>
                <a:gd name="T98" fmla="*/ 1727 w 1776"/>
                <a:gd name="T99" fmla="*/ 1784 h 1784"/>
                <a:gd name="T100" fmla="*/ 1762 w 1776"/>
                <a:gd name="T101" fmla="*/ 1714 h 17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776" h="1784">
                  <a:moveTo>
                    <a:pt x="0" y="1784"/>
                  </a:moveTo>
                  <a:lnTo>
                    <a:pt x="0" y="0"/>
                  </a:lnTo>
                  <a:lnTo>
                    <a:pt x="0" y="595"/>
                  </a:lnTo>
                  <a:lnTo>
                    <a:pt x="7" y="1399"/>
                  </a:lnTo>
                  <a:lnTo>
                    <a:pt x="14" y="1686"/>
                  </a:lnTo>
                  <a:lnTo>
                    <a:pt x="21" y="1756"/>
                  </a:lnTo>
                  <a:lnTo>
                    <a:pt x="28" y="1777"/>
                  </a:lnTo>
                  <a:lnTo>
                    <a:pt x="35" y="1784"/>
                  </a:lnTo>
                  <a:lnTo>
                    <a:pt x="42" y="1784"/>
                  </a:lnTo>
                  <a:lnTo>
                    <a:pt x="49" y="1784"/>
                  </a:lnTo>
                  <a:lnTo>
                    <a:pt x="56" y="1784"/>
                  </a:lnTo>
                  <a:lnTo>
                    <a:pt x="63" y="1784"/>
                  </a:lnTo>
                  <a:lnTo>
                    <a:pt x="70" y="1784"/>
                  </a:lnTo>
                  <a:lnTo>
                    <a:pt x="77" y="1784"/>
                  </a:lnTo>
                  <a:lnTo>
                    <a:pt x="84" y="1784"/>
                  </a:lnTo>
                  <a:lnTo>
                    <a:pt x="91" y="1784"/>
                  </a:lnTo>
                  <a:lnTo>
                    <a:pt x="98" y="1784"/>
                  </a:lnTo>
                  <a:lnTo>
                    <a:pt x="105" y="1784"/>
                  </a:lnTo>
                  <a:lnTo>
                    <a:pt x="112" y="1784"/>
                  </a:lnTo>
                  <a:lnTo>
                    <a:pt x="119" y="1784"/>
                  </a:lnTo>
                  <a:lnTo>
                    <a:pt x="126" y="1784"/>
                  </a:lnTo>
                  <a:lnTo>
                    <a:pt x="133" y="1777"/>
                  </a:lnTo>
                  <a:lnTo>
                    <a:pt x="140" y="1756"/>
                  </a:lnTo>
                  <a:lnTo>
                    <a:pt x="147" y="1728"/>
                  </a:lnTo>
                  <a:lnTo>
                    <a:pt x="154" y="1707"/>
                  </a:lnTo>
                  <a:lnTo>
                    <a:pt x="161" y="1728"/>
                  </a:lnTo>
                  <a:lnTo>
                    <a:pt x="168" y="1756"/>
                  </a:lnTo>
                  <a:lnTo>
                    <a:pt x="175" y="1777"/>
                  </a:lnTo>
                  <a:lnTo>
                    <a:pt x="182" y="1784"/>
                  </a:lnTo>
                  <a:lnTo>
                    <a:pt x="189" y="1784"/>
                  </a:lnTo>
                  <a:lnTo>
                    <a:pt x="196" y="1784"/>
                  </a:lnTo>
                  <a:lnTo>
                    <a:pt x="203" y="1784"/>
                  </a:lnTo>
                  <a:lnTo>
                    <a:pt x="210" y="1784"/>
                  </a:lnTo>
                  <a:lnTo>
                    <a:pt x="217" y="1777"/>
                  </a:lnTo>
                  <a:lnTo>
                    <a:pt x="224" y="1749"/>
                  </a:lnTo>
                  <a:lnTo>
                    <a:pt x="231" y="1707"/>
                  </a:lnTo>
                  <a:lnTo>
                    <a:pt x="238" y="1679"/>
                  </a:lnTo>
                  <a:lnTo>
                    <a:pt x="245" y="1707"/>
                  </a:lnTo>
                  <a:lnTo>
                    <a:pt x="252" y="1749"/>
                  </a:lnTo>
                  <a:lnTo>
                    <a:pt x="258" y="1777"/>
                  </a:lnTo>
                  <a:lnTo>
                    <a:pt x="265" y="1784"/>
                  </a:lnTo>
                  <a:lnTo>
                    <a:pt x="272" y="1784"/>
                  </a:lnTo>
                  <a:lnTo>
                    <a:pt x="279" y="1777"/>
                  </a:lnTo>
                  <a:lnTo>
                    <a:pt x="286" y="1749"/>
                  </a:lnTo>
                  <a:lnTo>
                    <a:pt x="293" y="1707"/>
                  </a:lnTo>
                  <a:lnTo>
                    <a:pt x="300" y="1686"/>
                  </a:lnTo>
                  <a:lnTo>
                    <a:pt x="307" y="1707"/>
                  </a:lnTo>
                  <a:lnTo>
                    <a:pt x="314" y="1749"/>
                  </a:lnTo>
                  <a:lnTo>
                    <a:pt x="321" y="1770"/>
                  </a:lnTo>
                  <a:lnTo>
                    <a:pt x="328" y="1756"/>
                  </a:lnTo>
                  <a:lnTo>
                    <a:pt x="335" y="1728"/>
                  </a:lnTo>
                  <a:lnTo>
                    <a:pt x="342" y="1714"/>
                  </a:lnTo>
                  <a:lnTo>
                    <a:pt x="349" y="1728"/>
                  </a:lnTo>
                  <a:lnTo>
                    <a:pt x="356" y="1756"/>
                  </a:lnTo>
                  <a:lnTo>
                    <a:pt x="363" y="1770"/>
                  </a:lnTo>
                  <a:lnTo>
                    <a:pt x="370" y="1749"/>
                  </a:lnTo>
                  <a:lnTo>
                    <a:pt x="377" y="1714"/>
                  </a:lnTo>
                  <a:lnTo>
                    <a:pt x="384" y="1693"/>
                  </a:lnTo>
                  <a:lnTo>
                    <a:pt x="391" y="1700"/>
                  </a:lnTo>
                  <a:lnTo>
                    <a:pt x="398" y="1707"/>
                  </a:lnTo>
                  <a:lnTo>
                    <a:pt x="405" y="1672"/>
                  </a:lnTo>
                  <a:lnTo>
                    <a:pt x="412" y="1637"/>
                  </a:lnTo>
                  <a:lnTo>
                    <a:pt x="419" y="1672"/>
                  </a:lnTo>
                  <a:lnTo>
                    <a:pt x="426" y="1707"/>
                  </a:lnTo>
                  <a:lnTo>
                    <a:pt x="433" y="1700"/>
                  </a:lnTo>
                  <a:lnTo>
                    <a:pt x="440" y="1686"/>
                  </a:lnTo>
                  <a:lnTo>
                    <a:pt x="447" y="1700"/>
                  </a:lnTo>
                  <a:lnTo>
                    <a:pt x="454" y="1707"/>
                  </a:lnTo>
                  <a:lnTo>
                    <a:pt x="461" y="1665"/>
                  </a:lnTo>
                  <a:lnTo>
                    <a:pt x="468" y="1623"/>
                  </a:lnTo>
                  <a:lnTo>
                    <a:pt x="475" y="1637"/>
                  </a:lnTo>
                  <a:lnTo>
                    <a:pt x="482" y="1644"/>
                  </a:lnTo>
                  <a:lnTo>
                    <a:pt x="489" y="1644"/>
                  </a:lnTo>
                  <a:lnTo>
                    <a:pt x="496" y="1644"/>
                  </a:lnTo>
                  <a:lnTo>
                    <a:pt x="503" y="1623"/>
                  </a:lnTo>
                  <a:lnTo>
                    <a:pt x="510" y="1602"/>
                  </a:lnTo>
                  <a:lnTo>
                    <a:pt x="517" y="1609"/>
                  </a:lnTo>
                  <a:lnTo>
                    <a:pt x="524" y="1595"/>
                  </a:lnTo>
                  <a:lnTo>
                    <a:pt x="531" y="1546"/>
                  </a:lnTo>
                  <a:lnTo>
                    <a:pt x="538" y="1532"/>
                  </a:lnTo>
                  <a:lnTo>
                    <a:pt x="545" y="1532"/>
                  </a:lnTo>
                  <a:lnTo>
                    <a:pt x="552" y="1532"/>
                  </a:lnTo>
                  <a:lnTo>
                    <a:pt x="559" y="1525"/>
                  </a:lnTo>
                  <a:lnTo>
                    <a:pt x="566" y="1511"/>
                  </a:lnTo>
                  <a:lnTo>
                    <a:pt x="573" y="1504"/>
                  </a:lnTo>
                  <a:lnTo>
                    <a:pt x="580" y="1518"/>
                  </a:lnTo>
                  <a:lnTo>
                    <a:pt x="587" y="1525"/>
                  </a:lnTo>
                  <a:lnTo>
                    <a:pt x="594" y="1497"/>
                  </a:lnTo>
                  <a:lnTo>
                    <a:pt x="601" y="1448"/>
                  </a:lnTo>
                  <a:lnTo>
                    <a:pt x="608" y="1385"/>
                  </a:lnTo>
                  <a:lnTo>
                    <a:pt x="615" y="1315"/>
                  </a:lnTo>
                  <a:lnTo>
                    <a:pt x="622" y="1343"/>
                  </a:lnTo>
                  <a:lnTo>
                    <a:pt x="629" y="1392"/>
                  </a:lnTo>
                  <a:lnTo>
                    <a:pt x="636" y="1350"/>
                  </a:lnTo>
                  <a:lnTo>
                    <a:pt x="643" y="1336"/>
                  </a:lnTo>
                  <a:lnTo>
                    <a:pt x="650" y="1364"/>
                  </a:lnTo>
                  <a:lnTo>
                    <a:pt x="657" y="1301"/>
                  </a:lnTo>
                  <a:lnTo>
                    <a:pt x="664" y="1224"/>
                  </a:lnTo>
                  <a:lnTo>
                    <a:pt x="671" y="1273"/>
                  </a:lnTo>
                  <a:lnTo>
                    <a:pt x="678" y="1315"/>
                  </a:lnTo>
                  <a:lnTo>
                    <a:pt x="685" y="1210"/>
                  </a:lnTo>
                  <a:lnTo>
                    <a:pt x="692" y="1070"/>
                  </a:lnTo>
                  <a:lnTo>
                    <a:pt x="699" y="1007"/>
                  </a:lnTo>
                  <a:lnTo>
                    <a:pt x="706" y="986"/>
                  </a:lnTo>
                  <a:lnTo>
                    <a:pt x="713" y="923"/>
                  </a:lnTo>
                  <a:lnTo>
                    <a:pt x="720" y="888"/>
                  </a:lnTo>
                  <a:lnTo>
                    <a:pt x="727" y="923"/>
                  </a:lnTo>
                  <a:lnTo>
                    <a:pt x="734" y="916"/>
                  </a:lnTo>
                  <a:lnTo>
                    <a:pt x="741" y="853"/>
                  </a:lnTo>
                  <a:lnTo>
                    <a:pt x="748" y="839"/>
                  </a:lnTo>
                  <a:lnTo>
                    <a:pt x="755" y="776"/>
                  </a:lnTo>
                  <a:lnTo>
                    <a:pt x="762" y="650"/>
                  </a:lnTo>
                  <a:lnTo>
                    <a:pt x="769" y="567"/>
                  </a:lnTo>
                  <a:lnTo>
                    <a:pt x="776" y="588"/>
                  </a:lnTo>
                  <a:lnTo>
                    <a:pt x="783" y="643"/>
                  </a:lnTo>
                  <a:lnTo>
                    <a:pt x="790" y="657"/>
                  </a:lnTo>
                  <a:lnTo>
                    <a:pt x="797" y="532"/>
                  </a:lnTo>
                  <a:lnTo>
                    <a:pt x="804" y="357"/>
                  </a:lnTo>
                  <a:lnTo>
                    <a:pt x="811" y="504"/>
                  </a:lnTo>
                  <a:lnTo>
                    <a:pt x="818" y="448"/>
                  </a:lnTo>
                  <a:lnTo>
                    <a:pt x="825" y="182"/>
                  </a:lnTo>
                  <a:lnTo>
                    <a:pt x="832" y="301"/>
                  </a:lnTo>
                  <a:lnTo>
                    <a:pt x="839" y="462"/>
                  </a:lnTo>
                  <a:lnTo>
                    <a:pt x="846" y="350"/>
                  </a:lnTo>
                  <a:lnTo>
                    <a:pt x="853" y="112"/>
                  </a:lnTo>
                  <a:lnTo>
                    <a:pt x="860" y="91"/>
                  </a:lnTo>
                  <a:lnTo>
                    <a:pt x="867" y="210"/>
                  </a:lnTo>
                  <a:lnTo>
                    <a:pt x="874" y="322"/>
                  </a:lnTo>
                  <a:lnTo>
                    <a:pt x="881" y="399"/>
                  </a:lnTo>
                  <a:lnTo>
                    <a:pt x="888" y="364"/>
                  </a:lnTo>
                  <a:lnTo>
                    <a:pt x="895" y="420"/>
                  </a:lnTo>
                  <a:lnTo>
                    <a:pt x="902" y="581"/>
                  </a:lnTo>
                  <a:lnTo>
                    <a:pt x="909" y="588"/>
                  </a:lnTo>
                  <a:lnTo>
                    <a:pt x="916" y="560"/>
                  </a:lnTo>
                  <a:lnTo>
                    <a:pt x="923" y="609"/>
                  </a:lnTo>
                  <a:lnTo>
                    <a:pt x="930" y="616"/>
                  </a:lnTo>
                  <a:lnTo>
                    <a:pt x="937" y="713"/>
                  </a:lnTo>
                  <a:lnTo>
                    <a:pt x="944" y="853"/>
                  </a:lnTo>
                  <a:lnTo>
                    <a:pt x="951" y="916"/>
                  </a:lnTo>
                  <a:lnTo>
                    <a:pt x="958" y="972"/>
                  </a:lnTo>
                  <a:lnTo>
                    <a:pt x="965" y="1063"/>
                  </a:lnTo>
                  <a:lnTo>
                    <a:pt x="972" y="1154"/>
                  </a:lnTo>
                  <a:lnTo>
                    <a:pt x="979" y="1203"/>
                  </a:lnTo>
                  <a:lnTo>
                    <a:pt x="986" y="1210"/>
                  </a:lnTo>
                  <a:lnTo>
                    <a:pt x="993" y="1245"/>
                  </a:lnTo>
                  <a:lnTo>
                    <a:pt x="1000" y="1315"/>
                  </a:lnTo>
                  <a:lnTo>
                    <a:pt x="1007" y="1357"/>
                  </a:lnTo>
                  <a:lnTo>
                    <a:pt x="1014" y="1385"/>
                  </a:lnTo>
                  <a:lnTo>
                    <a:pt x="1021" y="1392"/>
                  </a:lnTo>
                  <a:lnTo>
                    <a:pt x="1028" y="1385"/>
                  </a:lnTo>
                  <a:lnTo>
                    <a:pt x="1035" y="1406"/>
                  </a:lnTo>
                  <a:lnTo>
                    <a:pt x="1042" y="1441"/>
                  </a:lnTo>
                  <a:lnTo>
                    <a:pt x="1049" y="1469"/>
                  </a:lnTo>
                  <a:lnTo>
                    <a:pt x="1056" y="1476"/>
                  </a:lnTo>
                  <a:lnTo>
                    <a:pt x="1063" y="1490"/>
                  </a:lnTo>
                  <a:lnTo>
                    <a:pt x="1070" y="1518"/>
                  </a:lnTo>
                  <a:lnTo>
                    <a:pt x="1077" y="1532"/>
                  </a:lnTo>
                  <a:lnTo>
                    <a:pt x="1084" y="1546"/>
                  </a:lnTo>
                  <a:lnTo>
                    <a:pt x="1091" y="1560"/>
                  </a:lnTo>
                  <a:lnTo>
                    <a:pt x="1098" y="1574"/>
                  </a:lnTo>
                  <a:lnTo>
                    <a:pt x="1105" y="1588"/>
                  </a:lnTo>
                  <a:lnTo>
                    <a:pt x="1112" y="1609"/>
                  </a:lnTo>
                  <a:lnTo>
                    <a:pt x="1119" y="1623"/>
                  </a:lnTo>
                  <a:lnTo>
                    <a:pt x="1126" y="1637"/>
                  </a:lnTo>
                  <a:lnTo>
                    <a:pt x="1133" y="1644"/>
                  </a:lnTo>
                  <a:lnTo>
                    <a:pt x="1140" y="1644"/>
                  </a:lnTo>
                  <a:lnTo>
                    <a:pt x="1147" y="1637"/>
                  </a:lnTo>
                  <a:lnTo>
                    <a:pt x="1154" y="1637"/>
                  </a:lnTo>
                  <a:lnTo>
                    <a:pt x="1161" y="1637"/>
                  </a:lnTo>
                  <a:lnTo>
                    <a:pt x="1168" y="1637"/>
                  </a:lnTo>
                  <a:lnTo>
                    <a:pt x="1175" y="1630"/>
                  </a:lnTo>
                  <a:lnTo>
                    <a:pt x="1182" y="1623"/>
                  </a:lnTo>
                  <a:lnTo>
                    <a:pt x="1189" y="1623"/>
                  </a:lnTo>
                  <a:lnTo>
                    <a:pt x="1196" y="1623"/>
                  </a:lnTo>
                  <a:lnTo>
                    <a:pt x="1203" y="1630"/>
                  </a:lnTo>
                  <a:lnTo>
                    <a:pt x="1210" y="1630"/>
                  </a:lnTo>
                  <a:lnTo>
                    <a:pt x="1217" y="1630"/>
                  </a:lnTo>
                  <a:lnTo>
                    <a:pt x="1224" y="1637"/>
                  </a:lnTo>
                  <a:lnTo>
                    <a:pt x="1231" y="1637"/>
                  </a:lnTo>
                  <a:lnTo>
                    <a:pt x="1238" y="1637"/>
                  </a:lnTo>
                  <a:lnTo>
                    <a:pt x="1245" y="1637"/>
                  </a:lnTo>
                  <a:lnTo>
                    <a:pt x="1252" y="1644"/>
                  </a:lnTo>
                  <a:lnTo>
                    <a:pt x="1259" y="1651"/>
                  </a:lnTo>
                  <a:lnTo>
                    <a:pt x="1266" y="1651"/>
                  </a:lnTo>
                  <a:lnTo>
                    <a:pt x="1273" y="1658"/>
                  </a:lnTo>
                  <a:lnTo>
                    <a:pt x="1280" y="1665"/>
                  </a:lnTo>
                  <a:lnTo>
                    <a:pt x="1287" y="1665"/>
                  </a:lnTo>
                  <a:lnTo>
                    <a:pt x="1294" y="1665"/>
                  </a:lnTo>
                  <a:lnTo>
                    <a:pt x="1301" y="1672"/>
                  </a:lnTo>
                  <a:lnTo>
                    <a:pt x="1308" y="1672"/>
                  </a:lnTo>
                  <a:lnTo>
                    <a:pt x="1315" y="1672"/>
                  </a:lnTo>
                  <a:lnTo>
                    <a:pt x="1322" y="1672"/>
                  </a:lnTo>
                  <a:lnTo>
                    <a:pt x="1329" y="1665"/>
                  </a:lnTo>
                  <a:lnTo>
                    <a:pt x="1336" y="1672"/>
                  </a:lnTo>
                  <a:lnTo>
                    <a:pt x="1343" y="1679"/>
                  </a:lnTo>
                  <a:lnTo>
                    <a:pt x="1350" y="1693"/>
                  </a:lnTo>
                  <a:lnTo>
                    <a:pt x="1357" y="1693"/>
                  </a:lnTo>
                  <a:lnTo>
                    <a:pt x="1364" y="1693"/>
                  </a:lnTo>
                  <a:lnTo>
                    <a:pt x="1371" y="1686"/>
                  </a:lnTo>
                  <a:lnTo>
                    <a:pt x="1378" y="1672"/>
                  </a:lnTo>
                  <a:lnTo>
                    <a:pt x="1385" y="1672"/>
                  </a:lnTo>
                  <a:lnTo>
                    <a:pt x="1392" y="1672"/>
                  </a:lnTo>
                  <a:lnTo>
                    <a:pt x="1399" y="1672"/>
                  </a:lnTo>
                  <a:lnTo>
                    <a:pt x="1406" y="1679"/>
                  </a:lnTo>
                  <a:lnTo>
                    <a:pt x="1413" y="1686"/>
                  </a:lnTo>
                  <a:lnTo>
                    <a:pt x="1420" y="1693"/>
                  </a:lnTo>
                  <a:lnTo>
                    <a:pt x="1427" y="1700"/>
                  </a:lnTo>
                  <a:lnTo>
                    <a:pt x="1434" y="1707"/>
                  </a:lnTo>
                  <a:lnTo>
                    <a:pt x="1441" y="1707"/>
                  </a:lnTo>
                  <a:lnTo>
                    <a:pt x="1448" y="1714"/>
                  </a:lnTo>
                  <a:lnTo>
                    <a:pt x="1455" y="1714"/>
                  </a:lnTo>
                  <a:lnTo>
                    <a:pt x="1462" y="1714"/>
                  </a:lnTo>
                  <a:lnTo>
                    <a:pt x="1469" y="1714"/>
                  </a:lnTo>
                  <a:lnTo>
                    <a:pt x="1476" y="1714"/>
                  </a:lnTo>
                  <a:lnTo>
                    <a:pt x="1482" y="1721"/>
                  </a:lnTo>
                  <a:lnTo>
                    <a:pt x="1489" y="1728"/>
                  </a:lnTo>
                  <a:lnTo>
                    <a:pt x="1496" y="1728"/>
                  </a:lnTo>
                  <a:lnTo>
                    <a:pt x="1503" y="1735"/>
                  </a:lnTo>
                  <a:lnTo>
                    <a:pt x="1510" y="1735"/>
                  </a:lnTo>
                  <a:lnTo>
                    <a:pt x="1517" y="1735"/>
                  </a:lnTo>
                  <a:lnTo>
                    <a:pt x="1524" y="1735"/>
                  </a:lnTo>
                  <a:lnTo>
                    <a:pt x="1531" y="1742"/>
                  </a:lnTo>
                  <a:lnTo>
                    <a:pt x="1538" y="1742"/>
                  </a:lnTo>
                  <a:lnTo>
                    <a:pt x="1545" y="1749"/>
                  </a:lnTo>
                  <a:lnTo>
                    <a:pt x="1552" y="1749"/>
                  </a:lnTo>
                  <a:lnTo>
                    <a:pt x="1559" y="1756"/>
                  </a:lnTo>
                  <a:lnTo>
                    <a:pt x="1566" y="1763"/>
                  </a:lnTo>
                  <a:lnTo>
                    <a:pt x="1573" y="1763"/>
                  </a:lnTo>
                  <a:lnTo>
                    <a:pt x="1580" y="1763"/>
                  </a:lnTo>
                  <a:lnTo>
                    <a:pt x="1587" y="1763"/>
                  </a:lnTo>
                  <a:lnTo>
                    <a:pt x="1594" y="1763"/>
                  </a:lnTo>
                  <a:lnTo>
                    <a:pt x="1601" y="1756"/>
                  </a:lnTo>
                  <a:lnTo>
                    <a:pt x="1608" y="1756"/>
                  </a:lnTo>
                  <a:lnTo>
                    <a:pt x="1615" y="1756"/>
                  </a:lnTo>
                  <a:lnTo>
                    <a:pt x="1622" y="1756"/>
                  </a:lnTo>
                  <a:lnTo>
                    <a:pt x="1629" y="1763"/>
                  </a:lnTo>
                  <a:lnTo>
                    <a:pt x="1636" y="1763"/>
                  </a:lnTo>
                  <a:lnTo>
                    <a:pt x="1643" y="1763"/>
                  </a:lnTo>
                  <a:lnTo>
                    <a:pt x="1650" y="1770"/>
                  </a:lnTo>
                  <a:lnTo>
                    <a:pt x="1657" y="1770"/>
                  </a:lnTo>
                  <a:lnTo>
                    <a:pt x="1664" y="1770"/>
                  </a:lnTo>
                  <a:lnTo>
                    <a:pt x="1671" y="1770"/>
                  </a:lnTo>
                  <a:lnTo>
                    <a:pt x="1678" y="1777"/>
                  </a:lnTo>
                  <a:lnTo>
                    <a:pt x="1685" y="1777"/>
                  </a:lnTo>
                  <a:lnTo>
                    <a:pt x="1692" y="1777"/>
                  </a:lnTo>
                  <a:lnTo>
                    <a:pt x="1699" y="1777"/>
                  </a:lnTo>
                  <a:lnTo>
                    <a:pt x="1706" y="1784"/>
                  </a:lnTo>
                  <a:lnTo>
                    <a:pt x="1713" y="1784"/>
                  </a:lnTo>
                  <a:lnTo>
                    <a:pt x="1720" y="1784"/>
                  </a:lnTo>
                  <a:lnTo>
                    <a:pt x="1727" y="1784"/>
                  </a:lnTo>
                  <a:lnTo>
                    <a:pt x="1734" y="1784"/>
                  </a:lnTo>
                  <a:lnTo>
                    <a:pt x="1741" y="1784"/>
                  </a:lnTo>
                  <a:lnTo>
                    <a:pt x="1748" y="1784"/>
                  </a:lnTo>
                  <a:lnTo>
                    <a:pt x="1755" y="1777"/>
                  </a:lnTo>
                  <a:lnTo>
                    <a:pt x="1762" y="1714"/>
                  </a:lnTo>
                  <a:lnTo>
                    <a:pt x="1769" y="1497"/>
                  </a:lnTo>
                  <a:lnTo>
                    <a:pt x="1776" y="1315"/>
                  </a:lnTo>
                </a:path>
              </a:pathLst>
            </a:custGeom>
            <a:noFill/>
            <a:ln w="11113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grpSp>
          <p:nvGrpSpPr>
            <p:cNvPr id="533" name="Group 90"/>
            <p:cNvGrpSpPr>
              <a:grpSpLocks/>
            </p:cNvGrpSpPr>
            <p:nvPr/>
          </p:nvGrpSpPr>
          <p:grpSpPr bwMode="auto">
            <a:xfrm>
              <a:off x="2525998" y="1661709"/>
              <a:ext cx="577850" cy="66675"/>
              <a:chOff x="1845" y="2225"/>
              <a:chExt cx="728" cy="84"/>
            </a:xfrm>
          </p:grpSpPr>
          <p:sp>
            <p:nvSpPr>
              <p:cNvPr id="536" name="Line 87"/>
              <p:cNvSpPr>
                <a:spLocks noChangeShapeType="1"/>
              </p:cNvSpPr>
              <p:nvPr/>
            </p:nvSpPr>
            <p:spPr bwMode="auto">
              <a:xfrm>
                <a:off x="1845" y="2225"/>
                <a:ext cx="1" cy="8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537" name="Line 88"/>
              <p:cNvSpPr>
                <a:spLocks noChangeShapeType="1"/>
              </p:cNvSpPr>
              <p:nvPr/>
            </p:nvSpPr>
            <p:spPr bwMode="auto">
              <a:xfrm>
                <a:off x="2572" y="2225"/>
                <a:ext cx="1" cy="8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538" name="Line 89"/>
              <p:cNvSpPr>
                <a:spLocks noChangeShapeType="1"/>
              </p:cNvSpPr>
              <p:nvPr/>
            </p:nvSpPr>
            <p:spPr bwMode="auto">
              <a:xfrm>
                <a:off x="1845" y="2260"/>
                <a:ext cx="720" cy="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</p:grpSp>
        <p:sp>
          <p:nvSpPr>
            <p:cNvPr id="535" name="Rectangle 92"/>
            <p:cNvSpPr>
              <a:spLocks noChangeArrowheads="1"/>
            </p:cNvSpPr>
            <p:nvPr/>
          </p:nvSpPr>
          <p:spPr bwMode="auto">
            <a:xfrm>
              <a:off x="2668873" y="1462477"/>
              <a:ext cx="310356" cy="1690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r>
                <a:rPr lang="en-US" altLang="ja-JP" sz="1100" dirty="0">
                  <a:solidFill>
                    <a:srgbClr val="000000"/>
                  </a:solidFill>
                </a:rPr>
                <a:t>13.7</a:t>
              </a:r>
              <a:endParaRPr lang="en-US" altLang="ja-JP" dirty="0"/>
            </a:p>
          </p:txBody>
        </p:sp>
        <p:sp>
          <p:nvSpPr>
            <p:cNvPr id="539" name="Rectangle 110"/>
            <p:cNvSpPr>
              <a:spLocks noChangeArrowheads="1"/>
            </p:cNvSpPr>
            <p:nvPr/>
          </p:nvSpPr>
          <p:spPr bwMode="auto">
            <a:xfrm>
              <a:off x="3550461" y="903288"/>
              <a:ext cx="1438275" cy="1438275"/>
            </a:xfrm>
            <a:prstGeom prst="rect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 sz="1600"/>
            </a:p>
          </p:txBody>
        </p:sp>
        <p:sp>
          <p:nvSpPr>
            <p:cNvPr id="610" name="Freeform 189"/>
            <p:cNvSpPr>
              <a:spLocks/>
            </p:cNvSpPr>
            <p:nvPr/>
          </p:nvSpPr>
          <p:spPr bwMode="auto">
            <a:xfrm>
              <a:off x="3561573" y="986632"/>
              <a:ext cx="1416050" cy="1343819"/>
            </a:xfrm>
            <a:custGeom>
              <a:avLst/>
              <a:gdLst>
                <a:gd name="T0" fmla="*/ 14 w 1784"/>
                <a:gd name="T1" fmla="*/ 1630 h 1693"/>
                <a:gd name="T2" fmla="*/ 49 w 1784"/>
                <a:gd name="T3" fmla="*/ 1693 h 1693"/>
                <a:gd name="T4" fmla="*/ 84 w 1784"/>
                <a:gd name="T5" fmla="*/ 1693 h 1693"/>
                <a:gd name="T6" fmla="*/ 119 w 1784"/>
                <a:gd name="T7" fmla="*/ 1693 h 1693"/>
                <a:gd name="T8" fmla="*/ 154 w 1784"/>
                <a:gd name="T9" fmla="*/ 1616 h 1693"/>
                <a:gd name="T10" fmla="*/ 189 w 1784"/>
                <a:gd name="T11" fmla="*/ 1693 h 1693"/>
                <a:gd name="T12" fmla="*/ 224 w 1784"/>
                <a:gd name="T13" fmla="*/ 1672 h 1693"/>
                <a:gd name="T14" fmla="*/ 259 w 1784"/>
                <a:gd name="T15" fmla="*/ 1686 h 1693"/>
                <a:gd name="T16" fmla="*/ 294 w 1784"/>
                <a:gd name="T17" fmla="*/ 1609 h 1693"/>
                <a:gd name="T18" fmla="*/ 329 w 1784"/>
                <a:gd name="T19" fmla="*/ 1672 h 1693"/>
                <a:gd name="T20" fmla="*/ 364 w 1784"/>
                <a:gd name="T21" fmla="*/ 1679 h 1693"/>
                <a:gd name="T22" fmla="*/ 399 w 1784"/>
                <a:gd name="T23" fmla="*/ 1637 h 1693"/>
                <a:gd name="T24" fmla="*/ 434 w 1784"/>
                <a:gd name="T25" fmla="*/ 1602 h 1693"/>
                <a:gd name="T26" fmla="*/ 469 w 1784"/>
                <a:gd name="T27" fmla="*/ 1567 h 1693"/>
                <a:gd name="T28" fmla="*/ 504 w 1784"/>
                <a:gd name="T29" fmla="*/ 1546 h 1693"/>
                <a:gd name="T30" fmla="*/ 539 w 1784"/>
                <a:gd name="T31" fmla="*/ 1476 h 1693"/>
                <a:gd name="T32" fmla="*/ 574 w 1784"/>
                <a:gd name="T33" fmla="*/ 1406 h 1693"/>
                <a:gd name="T34" fmla="*/ 609 w 1784"/>
                <a:gd name="T35" fmla="*/ 1343 h 1693"/>
                <a:gd name="T36" fmla="*/ 644 w 1784"/>
                <a:gd name="T37" fmla="*/ 1245 h 1693"/>
                <a:gd name="T38" fmla="*/ 679 w 1784"/>
                <a:gd name="T39" fmla="*/ 1231 h 1693"/>
                <a:gd name="T40" fmla="*/ 714 w 1784"/>
                <a:gd name="T41" fmla="*/ 895 h 1693"/>
                <a:gd name="T42" fmla="*/ 749 w 1784"/>
                <a:gd name="T43" fmla="*/ 720 h 1693"/>
                <a:gd name="T44" fmla="*/ 784 w 1784"/>
                <a:gd name="T45" fmla="*/ 420 h 1693"/>
                <a:gd name="T46" fmla="*/ 819 w 1784"/>
                <a:gd name="T47" fmla="*/ 196 h 1693"/>
                <a:gd name="T48" fmla="*/ 854 w 1784"/>
                <a:gd name="T49" fmla="*/ 7 h 1693"/>
                <a:gd name="T50" fmla="*/ 889 w 1784"/>
                <a:gd name="T51" fmla="*/ 280 h 1693"/>
                <a:gd name="T52" fmla="*/ 924 w 1784"/>
                <a:gd name="T53" fmla="*/ 741 h 1693"/>
                <a:gd name="T54" fmla="*/ 959 w 1784"/>
                <a:gd name="T55" fmla="*/ 1112 h 1693"/>
                <a:gd name="T56" fmla="*/ 994 w 1784"/>
                <a:gd name="T57" fmla="*/ 1364 h 1693"/>
                <a:gd name="T58" fmla="*/ 1029 w 1784"/>
                <a:gd name="T59" fmla="*/ 1560 h 1693"/>
                <a:gd name="T60" fmla="*/ 1064 w 1784"/>
                <a:gd name="T61" fmla="*/ 1637 h 1693"/>
                <a:gd name="T62" fmla="*/ 1099 w 1784"/>
                <a:gd name="T63" fmla="*/ 1658 h 1693"/>
                <a:gd name="T64" fmla="*/ 1134 w 1784"/>
                <a:gd name="T65" fmla="*/ 1679 h 1693"/>
                <a:gd name="T66" fmla="*/ 1169 w 1784"/>
                <a:gd name="T67" fmla="*/ 1679 h 1693"/>
                <a:gd name="T68" fmla="*/ 1203 w 1784"/>
                <a:gd name="T69" fmla="*/ 1672 h 1693"/>
                <a:gd name="T70" fmla="*/ 1238 w 1784"/>
                <a:gd name="T71" fmla="*/ 1672 h 1693"/>
                <a:gd name="T72" fmla="*/ 1273 w 1784"/>
                <a:gd name="T73" fmla="*/ 1679 h 1693"/>
                <a:gd name="T74" fmla="*/ 1308 w 1784"/>
                <a:gd name="T75" fmla="*/ 1686 h 1693"/>
                <a:gd name="T76" fmla="*/ 1343 w 1784"/>
                <a:gd name="T77" fmla="*/ 1693 h 1693"/>
                <a:gd name="T78" fmla="*/ 1378 w 1784"/>
                <a:gd name="T79" fmla="*/ 1693 h 1693"/>
                <a:gd name="T80" fmla="*/ 1413 w 1784"/>
                <a:gd name="T81" fmla="*/ 1693 h 1693"/>
                <a:gd name="T82" fmla="*/ 1448 w 1784"/>
                <a:gd name="T83" fmla="*/ 1693 h 1693"/>
                <a:gd name="T84" fmla="*/ 1483 w 1784"/>
                <a:gd name="T85" fmla="*/ 1693 h 1693"/>
                <a:gd name="T86" fmla="*/ 1518 w 1784"/>
                <a:gd name="T87" fmla="*/ 1693 h 1693"/>
                <a:gd name="T88" fmla="*/ 1553 w 1784"/>
                <a:gd name="T89" fmla="*/ 1693 h 1693"/>
                <a:gd name="T90" fmla="*/ 1588 w 1784"/>
                <a:gd name="T91" fmla="*/ 1693 h 1693"/>
                <a:gd name="T92" fmla="*/ 1623 w 1784"/>
                <a:gd name="T93" fmla="*/ 1693 h 1693"/>
                <a:gd name="T94" fmla="*/ 1658 w 1784"/>
                <a:gd name="T95" fmla="*/ 1693 h 1693"/>
                <a:gd name="T96" fmla="*/ 1693 w 1784"/>
                <a:gd name="T97" fmla="*/ 1693 h 1693"/>
                <a:gd name="T98" fmla="*/ 1728 w 1784"/>
                <a:gd name="T99" fmla="*/ 1693 h 1693"/>
                <a:gd name="T100" fmla="*/ 1763 w 1784"/>
                <a:gd name="T101" fmla="*/ 1693 h 16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784" h="1693">
                  <a:moveTo>
                    <a:pt x="0" y="1693"/>
                  </a:moveTo>
                  <a:lnTo>
                    <a:pt x="0" y="105"/>
                  </a:lnTo>
                  <a:lnTo>
                    <a:pt x="0" y="839"/>
                  </a:lnTo>
                  <a:lnTo>
                    <a:pt x="7" y="1434"/>
                  </a:lnTo>
                  <a:lnTo>
                    <a:pt x="14" y="1630"/>
                  </a:lnTo>
                  <a:lnTo>
                    <a:pt x="21" y="1679"/>
                  </a:lnTo>
                  <a:lnTo>
                    <a:pt x="28" y="1693"/>
                  </a:lnTo>
                  <a:lnTo>
                    <a:pt x="35" y="1693"/>
                  </a:lnTo>
                  <a:lnTo>
                    <a:pt x="42" y="1693"/>
                  </a:lnTo>
                  <a:lnTo>
                    <a:pt x="49" y="1693"/>
                  </a:lnTo>
                  <a:lnTo>
                    <a:pt x="56" y="1693"/>
                  </a:lnTo>
                  <a:lnTo>
                    <a:pt x="63" y="1693"/>
                  </a:lnTo>
                  <a:lnTo>
                    <a:pt x="70" y="1693"/>
                  </a:lnTo>
                  <a:lnTo>
                    <a:pt x="77" y="1693"/>
                  </a:lnTo>
                  <a:lnTo>
                    <a:pt x="84" y="1693"/>
                  </a:lnTo>
                  <a:lnTo>
                    <a:pt x="91" y="1693"/>
                  </a:lnTo>
                  <a:lnTo>
                    <a:pt x="98" y="1693"/>
                  </a:lnTo>
                  <a:lnTo>
                    <a:pt x="105" y="1693"/>
                  </a:lnTo>
                  <a:lnTo>
                    <a:pt x="112" y="1693"/>
                  </a:lnTo>
                  <a:lnTo>
                    <a:pt x="119" y="1693"/>
                  </a:lnTo>
                  <a:lnTo>
                    <a:pt x="126" y="1693"/>
                  </a:lnTo>
                  <a:lnTo>
                    <a:pt x="133" y="1686"/>
                  </a:lnTo>
                  <a:lnTo>
                    <a:pt x="140" y="1672"/>
                  </a:lnTo>
                  <a:lnTo>
                    <a:pt x="147" y="1637"/>
                  </a:lnTo>
                  <a:lnTo>
                    <a:pt x="154" y="1616"/>
                  </a:lnTo>
                  <a:lnTo>
                    <a:pt x="161" y="1637"/>
                  </a:lnTo>
                  <a:lnTo>
                    <a:pt x="168" y="1672"/>
                  </a:lnTo>
                  <a:lnTo>
                    <a:pt x="175" y="1686"/>
                  </a:lnTo>
                  <a:lnTo>
                    <a:pt x="182" y="1693"/>
                  </a:lnTo>
                  <a:lnTo>
                    <a:pt x="189" y="1693"/>
                  </a:lnTo>
                  <a:lnTo>
                    <a:pt x="196" y="1693"/>
                  </a:lnTo>
                  <a:lnTo>
                    <a:pt x="203" y="1693"/>
                  </a:lnTo>
                  <a:lnTo>
                    <a:pt x="210" y="1693"/>
                  </a:lnTo>
                  <a:lnTo>
                    <a:pt x="217" y="1686"/>
                  </a:lnTo>
                  <a:lnTo>
                    <a:pt x="224" y="1672"/>
                  </a:lnTo>
                  <a:lnTo>
                    <a:pt x="231" y="1637"/>
                  </a:lnTo>
                  <a:lnTo>
                    <a:pt x="238" y="1623"/>
                  </a:lnTo>
                  <a:lnTo>
                    <a:pt x="245" y="1637"/>
                  </a:lnTo>
                  <a:lnTo>
                    <a:pt x="252" y="1672"/>
                  </a:lnTo>
                  <a:lnTo>
                    <a:pt x="259" y="1686"/>
                  </a:lnTo>
                  <a:lnTo>
                    <a:pt x="266" y="1693"/>
                  </a:lnTo>
                  <a:lnTo>
                    <a:pt x="273" y="1693"/>
                  </a:lnTo>
                  <a:lnTo>
                    <a:pt x="280" y="1686"/>
                  </a:lnTo>
                  <a:lnTo>
                    <a:pt x="287" y="1665"/>
                  </a:lnTo>
                  <a:lnTo>
                    <a:pt x="294" y="1609"/>
                  </a:lnTo>
                  <a:lnTo>
                    <a:pt x="301" y="1574"/>
                  </a:lnTo>
                  <a:lnTo>
                    <a:pt x="308" y="1609"/>
                  </a:lnTo>
                  <a:lnTo>
                    <a:pt x="315" y="1658"/>
                  </a:lnTo>
                  <a:lnTo>
                    <a:pt x="322" y="1679"/>
                  </a:lnTo>
                  <a:lnTo>
                    <a:pt x="329" y="1672"/>
                  </a:lnTo>
                  <a:lnTo>
                    <a:pt x="336" y="1637"/>
                  </a:lnTo>
                  <a:lnTo>
                    <a:pt x="343" y="1623"/>
                  </a:lnTo>
                  <a:lnTo>
                    <a:pt x="350" y="1637"/>
                  </a:lnTo>
                  <a:lnTo>
                    <a:pt x="357" y="1672"/>
                  </a:lnTo>
                  <a:lnTo>
                    <a:pt x="364" y="1679"/>
                  </a:lnTo>
                  <a:lnTo>
                    <a:pt x="371" y="1665"/>
                  </a:lnTo>
                  <a:lnTo>
                    <a:pt x="378" y="1637"/>
                  </a:lnTo>
                  <a:lnTo>
                    <a:pt x="385" y="1616"/>
                  </a:lnTo>
                  <a:lnTo>
                    <a:pt x="392" y="1630"/>
                  </a:lnTo>
                  <a:lnTo>
                    <a:pt x="399" y="1637"/>
                  </a:lnTo>
                  <a:lnTo>
                    <a:pt x="406" y="1602"/>
                  </a:lnTo>
                  <a:lnTo>
                    <a:pt x="413" y="1581"/>
                  </a:lnTo>
                  <a:lnTo>
                    <a:pt x="420" y="1602"/>
                  </a:lnTo>
                  <a:lnTo>
                    <a:pt x="427" y="1630"/>
                  </a:lnTo>
                  <a:lnTo>
                    <a:pt x="434" y="1602"/>
                  </a:lnTo>
                  <a:lnTo>
                    <a:pt x="441" y="1574"/>
                  </a:lnTo>
                  <a:lnTo>
                    <a:pt x="448" y="1602"/>
                  </a:lnTo>
                  <a:lnTo>
                    <a:pt x="455" y="1630"/>
                  </a:lnTo>
                  <a:lnTo>
                    <a:pt x="462" y="1602"/>
                  </a:lnTo>
                  <a:lnTo>
                    <a:pt x="469" y="1567"/>
                  </a:lnTo>
                  <a:lnTo>
                    <a:pt x="476" y="1567"/>
                  </a:lnTo>
                  <a:lnTo>
                    <a:pt x="483" y="1553"/>
                  </a:lnTo>
                  <a:lnTo>
                    <a:pt x="490" y="1525"/>
                  </a:lnTo>
                  <a:lnTo>
                    <a:pt x="497" y="1546"/>
                  </a:lnTo>
                  <a:lnTo>
                    <a:pt x="504" y="1546"/>
                  </a:lnTo>
                  <a:lnTo>
                    <a:pt x="511" y="1525"/>
                  </a:lnTo>
                  <a:lnTo>
                    <a:pt x="518" y="1546"/>
                  </a:lnTo>
                  <a:lnTo>
                    <a:pt x="525" y="1539"/>
                  </a:lnTo>
                  <a:lnTo>
                    <a:pt x="532" y="1497"/>
                  </a:lnTo>
                  <a:lnTo>
                    <a:pt x="539" y="1476"/>
                  </a:lnTo>
                  <a:lnTo>
                    <a:pt x="546" y="1476"/>
                  </a:lnTo>
                  <a:lnTo>
                    <a:pt x="553" y="1476"/>
                  </a:lnTo>
                  <a:lnTo>
                    <a:pt x="560" y="1462"/>
                  </a:lnTo>
                  <a:lnTo>
                    <a:pt x="567" y="1434"/>
                  </a:lnTo>
                  <a:lnTo>
                    <a:pt x="574" y="1406"/>
                  </a:lnTo>
                  <a:lnTo>
                    <a:pt x="581" y="1392"/>
                  </a:lnTo>
                  <a:lnTo>
                    <a:pt x="588" y="1385"/>
                  </a:lnTo>
                  <a:lnTo>
                    <a:pt x="595" y="1392"/>
                  </a:lnTo>
                  <a:lnTo>
                    <a:pt x="602" y="1385"/>
                  </a:lnTo>
                  <a:lnTo>
                    <a:pt x="609" y="1343"/>
                  </a:lnTo>
                  <a:lnTo>
                    <a:pt x="616" y="1238"/>
                  </a:lnTo>
                  <a:lnTo>
                    <a:pt x="623" y="1231"/>
                  </a:lnTo>
                  <a:lnTo>
                    <a:pt x="630" y="1280"/>
                  </a:lnTo>
                  <a:lnTo>
                    <a:pt x="637" y="1238"/>
                  </a:lnTo>
                  <a:lnTo>
                    <a:pt x="644" y="1245"/>
                  </a:lnTo>
                  <a:lnTo>
                    <a:pt x="651" y="1266"/>
                  </a:lnTo>
                  <a:lnTo>
                    <a:pt x="658" y="1140"/>
                  </a:lnTo>
                  <a:lnTo>
                    <a:pt x="665" y="1042"/>
                  </a:lnTo>
                  <a:lnTo>
                    <a:pt x="672" y="1119"/>
                  </a:lnTo>
                  <a:lnTo>
                    <a:pt x="679" y="1231"/>
                  </a:lnTo>
                  <a:lnTo>
                    <a:pt x="686" y="1140"/>
                  </a:lnTo>
                  <a:lnTo>
                    <a:pt x="693" y="986"/>
                  </a:lnTo>
                  <a:lnTo>
                    <a:pt x="700" y="930"/>
                  </a:lnTo>
                  <a:lnTo>
                    <a:pt x="707" y="923"/>
                  </a:lnTo>
                  <a:lnTo>
                    <a:pt x="714" y="895"/>
                  </a:lnTo>
                  <a:lnTo>
                    <a:pt x="721" y="853"/>
                  </a:lnTo>
                  <a:lnTo>
                    <a:pt x="728" y="881"/>
                  </a:lnTo>
                  <a:lnTo>
                    <a:pt x="735" y="916"/>
                  </a:lnTo>
                  <a:lnTo>
                    <a:pt x="742" y="846"/>
                  </a:lnTo>
                  <a:lnTo>
                    <a:pt x="749" y="720"/>
                  </a:lnTo>
                  <a:lnTo>
                    <a:pt x="756" y="566"/>
                  </a:lnTo>
                  <a:lnTo>
                    <a:pt x="763" y="476"/>
                  </a:lnTo>
                  <a:lnTo>
                    <a:pt x="770" y="399"/>
                  </a:lnTo>
                  <a:lnTo>
                    <a:pt x="777" y="385"/>
                  </a:lnTo>
                  <a:lnTo>
                    <a:pt x="784" y="420"/>
                  </a:lnTo>
                  <a:lnTo>
                    <a:pt x="791" y="406"/>
                  </a:lnTo>
                  <a:lnTo>
                    <a:pt x="798" y="399"/>
                  </a:lnTo>
                  <a:lnTo>
                    <a:pt x="805" y="364"/>
                  </a:lnTo>
                  <a:lnTo>
                    <a:pt x="812" y="252"/>
                  </a:lnTo>
                  <a:lnTo>
                    <a:pt x="819" y="196"/>
                  </a:lnTo>
                  <a:lnTo>
                    <a:pt x="826" y="168"/>
                  </a:lnTo>
                  <a:lnTo>
                    <a:pt x="833" y="119"/>
                  </a:lnTo>
                  <a:lnTo>
                    <a:pt x="840" y="56"/>
                  </a:lnTo>
                  <a:lnTo>
                    <a:pt x="847" y="0"/>
                  </a:lnTo>
                  <a:lnTo>
                    <a:pt x="854" y="7"/>
                  </a:lnTo>
                  <a:lnTo>
                    <a:pt x="861" y="91"/>
                  </a:lnTo>
                  <a:lnTo>
                    <a:pt x="868" y="245"/>
                  </a:lnTo>
                  <a:lnTo>
                    <a:pt x="875" y="413"/>
                  </a:lnTo>
                  <a:lnTo>
                    <a:pt x="882" y="434"/>
                  </a:lnTo>
                  <a:lnTo>
                    <a:pt x="889" y="280"/>
                  </a:lnTo>
                  <a:lnTo>
                    <a:pt x="896" y="287"/>
                  </a:lnTo>
                  <a:lnTo>
                    <a:pt x="903" y="441"/>
                  </a:lnTo>
                  <a:lnTo>
                    <a:pt x="910" y="476"/>
                  </a:lnTo>
                  <a:lnTo>
                    <a:pt x="917" y="566"/>
                  </a:lnTo>
                  <a:lnTo>
                    <a:pt x="924" y="741"/>
                  </a:lnTo>
                  <a:lnTo>
                    <a:pt x="931" y="769"/>
                  </a:lnTo>
                  <a:lnTo>
                    <a:pt x="938" y="783"/>
                  </a:lnTo>
                  <a:lnTo>
                    <a:pt x="945" y="881"/>
                  </a:lnTo>
                  <a:lnTo>
                    <a:pt x="952" y="993"/>
                  </a:lnTo>
                  <a:lnTo>
                    <a:pt x="959" y="1112"/>
                  </a:lnTo>
                  <a:lnTo>
                    <a:pt x="966" y="1217"/>
                  </a:lnTo>
                  <a:lnTo>
                    <a:pt x="973" y="1273"/>
                  </a:lnTo>
                  <a:lnTo>
                    <a:pt x="980" y="1280"/>
                  </a:lnTo>
                  <a:lnTo>
                    <a:pt x="987" y="1294"/>
                  </a:lnTo>
                  <a:lnTo>
                    <a:pt x="994" y="1364"/>
                  </a:lnTo>
                  <a:lnTo>
                    <a:pt x="1001" y="1427"/>
                  </a:lnTo>
                  <a:lnTo>
                    <a:pt x="1008" y="1462"/>
                  </a:lnTo>
                  <a:lnTo>
                    <a:pt x="1015" y="1483"/>
                  </a:lnTo>
                  <a:lnTo>
                    <a:pt x="1022" y="1525"/>
                  </a:lnTo>
                  <a:lnTo>
                    <a:pt x="1029" y="1560"/>
                  </a:lnTo>
                  <a:lnTo>
                    <a:pt x="1036" y="1588"/>
                  </a:lnTo>
                  <a:lnTo>
                    <a:pt x="1043" y="1602"/>
                  </a:lnTo>
                  <a:lnTo>
                    <a:pt x="1050" y="1616"/>
                  </a:lnTo>
                  <a:lnTo>
                    <a:pt x="1057" y="1630"/>
                  </a:lnTo>
                  <a:lnTo>
                    <a:pt x="1064" y="1637"/>
                  </a:lnTo>
                  <a:lnTo>
                    <a:pt x="1071" y="1637"/>
                  </a:lnTo>
                  <a:lnTo>
                    <a:pt x="1078" y="1644"/>
                  </a:lnTo>
                  <a:lnTo>
                    <a:pt x="1085" y="1651"/>
                  </a:lnTo>
                  <a:lnTo>
                    <a:pt x="1092" y="1658"/>
                  </a:lnTo>
                  <a:lnTo>
                    <a:pt x="1099" y="1658"/>
                  </a:lnTo>
                  <a:lnTo>
                    <a:pt x="1106" y="1665"/>
                  </a:lnTo>
                  <a:lnTo>
                    <a:pt x="1113" y="1672"/>
                  </a:lnTo>
                  <a:lnTo>
                    <a:pt x="1120" y="1672"/>
                  </a:lnTo>
                  <a:lnTo>
                    <a:pt x="1127" y="1679"/>
                  </a:lnTo>
                  <a:lnTo>
                    <a:pt x="1134" y="1679"/>
                  </a:lnTo>
                  <a:lnTo>
                    <a:pt x="1141" y="1679"/>
                  </a:lnTo>
                  <a:lnTo>
                    <a:pt x="1148" y="1679"/>
                  </a:lnTo>
                  <a:lnTo>
                    <a:pt x="1155" y="1679"/>
                  </a:lnTo>
                  <a:lnTo>
                    <a:pt x="1162" y="1679"/>
                  </a:lnTo>
                  <a:lnTo>
                    <a:pt x="1169" y="1679"/>
                  </a:lnTo>
                  <a:lnTo>
                    <a:pt x="1176" y="1679"/>
                  </a:lnTo>
                  <a:lnTo>
                    <a:pt x="1183" y="1679"/>
                  </a:lnTo>
                  <a:lnTo>
                    <a:pt x="1190" y="1679"/>
                  </a:lnTo>
                  <a:lnTo>
                    <a:pt x="1197" y="1679"/>
                  </a:lnTo>
                  <a:lnTo>
                    <a:pt x="1203" y="1672"/>
                  </a:lnTo>
                  <a:lnTo>
                    <a:pt x="1210" y="1672"/>
                  </a:lnTo>
                  <a:lnTo>
                    <a:pt x="1217" y="1672"/>
                  </a:lnTo>
                  <a:lnTo>
                    <a:pt x="1224" y="1672"/>
                  </a:lnTo>
                  <a:lnTo>
                    <a:pt x="1231" y="1672"/>
                  </a:lnTo>
                  <a:lnTo>
                    <a:pt x="1238" y="1672"/>
                  </a:lnTo>
                  <a:lnTo>
                    <a:pt x="1245" y="1672"/>
                  </a:lnTo>
                  <a:lnTo>
                    <a:pt x="1252" y="1679"/>
                  </a:lnTo>
                  <a:lnTo>
                    <a:pt x="1259" y="1679"/>
                  </a:lnTo>
                  <a:lnTo>
                    <a:pt x="1266" y="1679"/>
                  </a:lnTo>
                  <a:lnTo>
                    <a:pt x="1273" y="1679"/>
                  </a:lnTo>
                  <a:lnTo>
                    <a:pt x="1280" y="1679"/>
                  </a:lnTo>
                  <a:lnTo>
                    <a:pt x="1287" y="1679"/>
                  </a:lnTo>
                  <a:lnTo>
                    <a:pt x="1294" y="1679"/>
                  </a:lnTo>
                  <a:lnTo>
                    <a:pt x="1301" y="1686"/>
                  </a:lnTo>
                  <a:lnTo>
                    <a:pt x="1308" y="1686"/>
                  </a:lnTo>
                  <a:lnTo>
                    <a:pt x="1315" y="1686"/>
                  </a:lnTo>
                  <a:lnTo>
                    <a:pt x="1322" y="1693"/>
                  </a:lnTo>
                  <a:lnTo>
                    <a:pt x="1329" y="1693"/>
                  </a:lnTo>
                  <a:lnTo>
                    <a:pt x="1336" y="1693"/>
                  </a:lnTo>
                  <a:lnTo>
                    <a:pt x="1343" y="1693"/>
                  </a:lnTo>
                  <a:lnTo>
                    <a:pt x="1350" y="1693"/>
                  </a:lnTo>
                  <a:lnTo>
                    <a:pt x="1357" y="1693"/>
                  </a:lnTo>
                  <a:lnTo>
                    <a:pt x="1364" y="1693"/>
                  </a:lnTo>
                  <a:lnTo>
                    <a:pt x="1371" y="1693"/>
                  </a:lnTo>
                  <a:lnTo>
                    <a:pt x="1378" y="1693"/>
                  </a:lnTo>
                  <a:lnTo>
                    <a:pt x="1385" y="1693"/>
                  </a:lnTo>
                  <a:lnTo>
                    <a:pt x="1392" y="1693"/>
                  </a:lnTo>
                  <a:lnTo>
                    <a:pt x="1399" y="1693"/>
                  </a:lnTo>
                  <a:lnTo>
                    <a:pt x="1406" y="1693"/>
                  </a:lnTo>
                  <a:lnTo>
                    <a:pt x="1413" y="1693"/>
                  </a:lnTo>
                  <a:lnTo>
                    <a:pt x="1420" y="1693"/>
                  </a:lnTo>
                  <a:lnTo>
                    <a:pt x="1427" y="1693"/>
                  </a:lnTo>
                  <a:lnTo>
                    <a:pt x="1434" y="1693"/>
                  </a:lnTo>
                  <a:lnTo>
                    <a:pt x="1441" y="1693"/>
                  </a:lnTo>
                  <a:lnTo>
                    <a:pt x="1448" y="1693"/>
                  </a:lnTo>
                  <a:lnTo>
                    <a:pt x="1455" y="1693"/>
                  </a:lnTo>
                  <a:lnTo>
                    <a:pt x="1462" y="1693"/>
                  </a:lnTo>
                  <a:lnTo>
                    <a:pt x="1469" y="1693"/>
                  </a:lnTo>
                  <a:lnTo>
                    <a:pt x="1476" y="1693"/>
                  </a:lnTo>
                  <a:lnTo>
                    <a:pt x="1483" y="1693"/>
                  </a:lnTo>
                  <a:lnTo>
                    <a:pt x="1490" y="1693"/>
                  </a:lnTo>
                  <a:lnTo>
                    <a:pt x="1497" y="1693"/>
                  </a:lnTo>
                  <a:lnTo>
                    <a:pt x="1504" y="1693"/>
                  </a:lnTo>
                  <a:lnTo>
                    <a:pt x="1511" y="1693"/>
                  </a:lnTo>
                  <a:lnTo>
                    <a:pt x="1518" y="1693"/>
                  </a:lnTo>
                  <a:lnTo>
                    <a:pt x="1525" y="1693"/>
                  </a:lnTo>
                  <a:lnTo>
                    <a:pt x="1532" y="1693"/>
                  </a:lnTo>
                  <a:lnTo>
                    <a:pt x="1539" y="1693"/>
                  </a:lnTo>
                  <a:lnTo>
                    <a:pt x="1546" y="1693"/>
                  </a:lnTo>
                  <a:lnTo>
                    <a:pt x="1553" y="1693"/>
                  </a:lnTo>
                  <a:lnTo>
                    <a:pt x="1560" y="1693"/>
                  </a:lnTo>
                  <a:lnTo>
                    <a:pt x="1567" y="1693"/>
                  </a:lnTo>
                  <a:lnTo>
                    <a:pt x="1574" y="1693"/>
                  </a:lnTo>
                  <a:lnTo>
                    <a:pt x="1581" y="1693"/>
                  </a:lnTo>
                  <a:lnTo>
                    <a:pt x="1588" y="1693"/>
                  </a:lnTo>
                  <a:lnTo>
                    <a:pt x="1595" y="1693"/>
                  </a:lnTo>
                  <a:lnTo>
                    <a:pt x="1602" y="1693"/>
                  </a:lnTo>
                  <a:lnTo>
                    <a:pt x="1609" y="1693"/>
                  </a:lnTo>
                  <a:lnTo>
                    <a:pt x="1616" y="1693"/>
                  </a:lnTo>
                  <a:lnTo>
                    <a:pt x="1623" y="1693"/>
                  </a:lnTo>
                  <a:lnTo>
                    <a:pt x="1630" y="1693"/>
                  </a:lnTo>
                  <a:lnTo>
                    <a:pt x="1637" y="1693"/>
                  </a:lnTo>
                  <a:lnTo>
                    <a:pt x="1644" y="1693"/>
                  </a:lnTo>
                  <a:lnTo>
                    <a:pt x="1651" y="1693"/>
                  </a:lnTo>
                  <a:lnTo>
                    <a:pt x="1658" y="1693"/>
                  </a:lnTo>
                  <a:lnTo>
                    <a:pt x="1665" y="1693"/>
                  </a:lnTo>
                  <a:lnTo>
                    <a:pt x="1672" y="1693"/>
                  </a:lnTo>
                  <a:lnTo>
                    <a:pt x="1679" y="1693"/>
                  </a:lnTo>
                  <a:lnTo>
                    <a:pt x="1686" y="1693"/>
                  </a:lnTo>
                  <a:lnTo>
                    <a:pt x="1693" y="1693"/>
                  </a:lnTo>
                  <a:lnTo>
                    <a:pt x="1700" y="1693"/>
                  </a:lnTo>
                  <a:lnTo>
                    <a:pt x="1707" y="1693"/>
                  </a:lnTo>
                  <a:lnTo>
                    <a:pt x="1714" y="1693"/>
                  </a:lnTo>
                  <a:lnTo>
                    <a:pt x="1721" y="1693"/>
                  </a:lnTo>
                  <a:lnTo>
                    <a:pt x="1728" y="1693"/>
                  </a:lnTo>
                  <a:lnTo>
                    <a:pt x="1735" y="1693"/>
                  </a:lnTo>
                  <a:lnTo>
                    <a:pt x="1742" y="1693"/>
                  </a:lnTo>
                  <a:lnTo>
                    <a:pt x="1749" y="1693"/>
                  </a:lnTo>
                  <a:lnTo>
                    <a:pt x="1756" y="1693"/>
                  </a:lnTo>
                  <a:lnTo>
                    <a:pt x="1763" y="1693"/>
                  </a:lnTo>
                  <a:lnTo>
                    <a:pt x="1770" y="1693"/>
                  </a:lnTo>
                  <a:lnTo>
                    <a:pt x="1777" y="1693"/>
                  </a:lnTo>
                  <a:lnTo>
                    <a:pt x="1784" y="1693"/>
                  </a:lnTo>
                  <a:lnTo>
                    <a:pt x="0" y="1693"/>
                  </a:lnTo>
                  <a:close/>
                </a:path>
              </a:pathLst>
            </a:custGeom>
            <a:solidFill>
              <a:srgbClr val="CCCCC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611" name="Freeform 190"/>
            <p:cNvSpPr>
              <a:spLocks/>
            </p:cNvSpPr>
            <p:nvPr/>
          </p:nvSpPr>
          <p:spPr bwMode="auto">
            <a:xfrm>
              <a:off x="3558820" y="986632"/>
              <a:ext cx="1410494" cy="1343819"/>
            </a:xfrm>
            <a:custGeom>
              <a:avLst/>
              <a:gdLst>
                <a:gd name="T0" fmla="*/ 14 w 1777"/>
                <a:gd name="T1" fmla="*/ 1672 h 1693"/>
                <a:gd name="T2" fmla="*/ 49 w 1777"/>
                <a:gd name="T3" fmla="*/ 1693 h 1693"/>
                <a:gd name="T4" fmla="*/ 84 w 1777"/>
                <a:gd name="T5" fmla="*/ 1693 h 1693"/>
                <a:gd name="T6" fmla="*/ 119 w 1777"/>
                <a:gd name="T7" fmla="*/ 1693 h 1693"/>
                <a:gd name="T8" fmla="*/ 154 w 1777"/>
                <a:gd name="T9" fmla="*/ 1686 h 1693"/>
                <a:gd name="T10" fmla="*/ 189 w 1777"/>
                <a:gd name="T11" fmla="*/ 1693 h 1693"/>
                <a:gd name="T12" fmla="*/ 224 w 1777"/>
                <a:gd name="T13" fmla="*/ 1686 h 1693"/>
                <a:gd name="T14" fmla="*/ 259 w 1777"/>
                <a:gd name="T15" fmla="*/ 1693 h 1693"/>
                <a:gd name="T16" fmla="*/ 294 w 1777"/>
                <a:gd name="T17" fmla="*/ 1672 h 1693"/>
                <a:gd name="T18" fmla="*/ 329 w 1777"/>
                <a:gd name="T19" fmla="*/ 1679 h 1693"/>
                <a:gd name="T20" fmla="*/ 364 w 1777"/>
                <a:gd name="T21" fmla="*/ 1679 h 1693"/>
                <a:gd name="T22" fmla="*/ 399 w 1777"/>
                <a:gd name="T23" fmla="*/ 1672 h 1693"/>
                <a:gd name="T24" fmla="*/ 434 w 1777"/>
                <a:gd name="T25" fmla="*/ 1658 h 1693"/>
                <a:gd name="T26" fmla="*/ 469 w 1777"/>
                <a:gd name="T27" fmla="*/ 1665 h 1693"/>
                <a:gd name="T28" fmla="*/ 504 w 1777"/>
                <a:gd name="T29" fmla="*/ 1637 h 1693"/>
                <a:gd name="T30" fmla="*/ 539 w 1777"/>
                <a:gd name="T31" fmla="*/ 1609 h 1693"/>
                <a:gd name="T32" fmla="*/ 574 w 1777"/>
                <a:gd name="T33" fmla="*/ 1588 h 1693"/>
                <a:gd name="T34" fmla="*/ 609 w 1777"/>
                <a:gd name="T35" fmla="*/ 1546 h 1693"/>
                <a:gd name="T36" fmla="*/ 644 w 1777"/>
                <a:gd name="T37" fmla="*/ 1497 h 1693"/>
                <a:gd name="T38" fmla="*/ 679 w 1777"/>
                <a:gd name="T39" fmla="*/ 1434 h 1693"/>
                <a:gd name="T40" fmla="*/ 714 w 1777"/>
                <a:gd name="T41" fmla="*/ 1301 h 1693"/>
                <a:gd name="T42" fmla="*/ 749 w 1777"/>
                <a:gd name="T43" fmla="*/ 1252 h 1693"/>
                <a:gd name="T44" fmla="*/ 784 w 1777"/>
                <a:gd name="T45" fmla="*/ 895 h 1693"/>
                <a:gd name="T46" fmla="*/ 819 w 1777"/>
                <a:gd name="T47" fmla="*/ 692 h 1693"/>
                <a:gd name="T48" fmla="*/ 854 w 1777"/>
                <a:gd name="T49" fmla="*/ 483 h 1693"/>
                <a:gd name="T50" fmla="*/ 889 w 1777"/>
                <a:gd name="T51" fmla="*/ 545 h 1693"/>
                <a:gd name="T52" fmla="*/ 924 w 1777"/>
                <a:gd name="T53" fmla="*/ 168 h 1693"/>
                <a:gd name="T54" fmla="*/ 959 w 1777"/>
                <a:gd name="T55" fmla="*/ 91 h 1693"/>
                <a:gd name="T56" fmla="*/ 994 w 1777"/>
                <a:gd name="T57" fmla="*/ 70 h 1693"/>
                <a:gd name="T58" fmla="*/ 1029 w 1777"/>
                <a:gd name="T59" fmla="*/ 196 h 1693"/>
                <a:gd name="T60" fmla="*/ 1064 w 1777"/>
                <a:gd name="T61" fmla="*/ 364 h 1693"/>
                <a:gd name="T62" fmla="*/ 1099 w 1777"/>
                <a:gd name="T63" fmla="*/ 392 h 1693"/>
                <a:gd name="T64" fmla="*/ 1134 w 1777"/>
                <a:gd name="T65" fmla="*/ 643 h 1693"/>
                <a:gd name="T66" fmla="*/ 1169 w 1777"/>
                <a:gd name="T67" fmla="*/ 601 h 1693"/>
                <a:gd name="T68" fmla="*/ 1203 w 1777"/>
                <a:gd name="T69" fmla="*/ 825 h 1693"/>
                <a:gd name="T70" fmla="*/ 1238 w 1777"/>
                <a:gd name="T71" fmla="*/ 881 h 1693"/>
                <a:gd name="T72" fmla="*/ 1273 w 1777"/>
                <a:gd name="T73" fmla="*/ 1014 h 1693"/>
                <a:gd name="T74" fmla="*/ 1308 w 1777"/>
                <a:gd name="T75" fmla="*/ 1084 h 1693"/>
                <a:gd name="T76" fmla="*/ 1343 w 1777"/>
                <a:gd name="T77" fmla="*/ 1203 h 1693"/>
                <a:gd name="T78" fmla="*/ 1378 w 1777"/>
                <a:gd name="T79" fmla="*/ 1203 h 1693"/>
                <a:gd name="T80" fmla="*/ 1413 w 1777"/>
                <a:gd name="T81" fmla="*/ 1308 h 1693"/>
                <a:gd name="T82" fmla="*/ 1448 w 1777"/>
                <a:gd name="T83" fmla="*/ 1434 h 1693"/>
                <a:gd name="T84" fmla="*/ 1483 w 1777"/>
                <a:gd name="T85" fmla="*/ 1476 h 1693"/>
                <a:gd name="T86" fmla="*/ 1518 w 1777"/>
                <a:gd name="T87" fmla="*/ 1574 h 1693"/>
                <a:gd name="T88" fmla="*/ 1553 w 1777"/>
                <a:gd name="T89" fmla="*/ 1595 h 1693"/>
                <a:gd name="T90" fmla="*/ 1588 w 1777"/>
                <a:gd name="T91" fmla="*/ 1630 h 1693"/>
                <a:gd name="T92" fmla="*/ 1623 w 1777"/>
                <a:gd name="T93" fmla="*/ 1651 h 1693"/>
                <a:gd name="T94" fmla="*/ 1658 w 1777"/>
                <a:gd name="T95" fmla="*/ 1658 h 1693"/>
                <a:gd name="T96" fmla="*/ 1693 w 1777"/>
                <a:gd name="T97" fmla="*/ 1672 h 1693"/>
                <a:gd name="T98" fmla="*/ 1728 w 1777"/>
                <a:gd name="T99" fmla="*/ 1672 h 1693"/>
                <a:gd name="T100" fmla="*/ 1763 w 1777"/>
                <a:gd name="T101" fmla="*/ 1462 h 16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777" h="1693">
                  <a:moveTo>
                    <a:pt x="0" y="1693"/>
                  </a:moveTo>
                  <a:lnTo>
                    <a:pt x="0" y="741"/>
                  </a:lnTo>
                  <a:lnTo>
                    <a:pt x="0" y="1238"/>
                  </a:lnTo>
                  <a:lnTo>
                    <a:pt x="7" y="1588"/>
                  </a:lnTo>
                  <a:lnTo>
                    <a:pt x="14" y="1672"/>
                  </a:lnTo>
                  <a:lnTo>
                    <a:pt x="21" y="1686"/>
                  </a:lnTo>
                  <a:lnTo>
                    <a:pt x="28" y="1693"/>
                  </a:lnTo>
                  <a:lnTo>
                    <a:pt x="35" y="1693"/>
                  </a:lnTo>
                  <a:lnTo>
                    <a:pt x="42" y="1693"/>
                  </a:lnTo>
                  <a:lnTo>
                    <a:pt x="49" y="1693"/>
                  </a:lnTo>
                  <a:lnTo>
                    <a:pt x="56" y="1693"/>
                  </a:lnTo>
                  <a:lnTo>
                    <a:pt x="63" y="1693"/>
                  </a:lnTo>
                  <a:lnTo>
                    <a:pt x="70" y="1693"/>
                  </a:lnTo>
                  <a:lnTo>
                    <a:pt x="77" y="1693"/>
                  </a:lnTo>
                  <a:lnTo>
                    <a:pt x="84" y="1693"/>
                  </a:lnTo>
                  <a:lnTo>
                    <a:pt x="91" y="1693"/>
                  </a:lnTo>
                  <a:lnTo>
                    <a:pt x="98" y="1693"/>
                  </a:lnTo>
                  <a:lnTo>
                    <a:pt x="105" y="1693"/>
                  </a:lnTo>
                  <a:lnTo>
                    <a:pt x="112" y="1693"/>
                  </a:lnTo>
                  <a:lnTo>
                    <a:pt x="119" y="1693"/>
                  </a:lnTo>
                  <a:lnTo>
                    <a:pt x="126" y="1693"/>
                  </a:lnTo>
                  <a:lnTo>
                    <a:pt x="133" y="1693"/>
                  </a:lnTo>
                  <a:lnTo>
                    <a:pt x="140" y="1693"/>
                  </a:lnTo>
                  <a:lnTo>
                    <a:pt x="147" y="1686"/>
                  </a:lnTo>
                  <a:lnTo>
                    <a:pt x="154" y="1686"/>
                  </a:lnTo>
                  <a:lnTo>
                    <a:pt x="161" y="1686"/>
                  </a:lnTo>
                  <a:lnTo>
                    <a:pt x="168" y="1693"/>
                  </a:lnTo>
                  <a:lnTo>
                    <a:pt x="175" y="1693"/>
                  </a:lnTo>
                  <a:lnTo>
                    <a:pt x="182" y="1693"/>
                  </a:lnTo>
                  <a:lnTo>
                    <a:pt x="189" y="1693"/>
                  </a:lnTo>
                  <a:lnTo>
                    <a:pt x="196" y="1693"/>
                  </a:lnTo>
                  <a:lnTo>
                    <a:pt x="203" y="1693"/>
                  </a:lnTo>
                  <a:lnTo>
                    <a:pt x="210" y="1693"/>
                  </a:lnTo>
                  <a:lnTo>
                    <a:pt x="217" y="1693"/>
                  </a:lnTo>
                  <a:lnTo>
                    <a:pt x="224" y="1686"/>
                  </a:lnTo>
                  <a:lnTo>
                    <a:pt x="231" y="1679"/>
                  </a:lnTo>
                  <a:lnTo>
                    <a:pt x="238" y="1679"/>
                  </a:lnTo>
                  <a:lnTo>
                    <a:pt x="245" y="1679"/>
                  </a:lnTo>
                  <a:lnTo>
                    <a:pt x="252" y="1686"/>
                  </a:lnTo>
                  <a:lnTo>
                    <a:pt x="259" y="1693"/>
                  </a:lnTo>
                  <a:lnTo>
                    <a:pt x="266" y="1693"/>
                  </a:lnTo>
                  <a:lnTo>
                    <a:pt x="273" y="1693"/>
                  </a:lnTo>
                  <a:lnTo>
                    <a:pt x="280" y="1686"/>
                  </a:lnTo>
                  <a:lnTo>
                    <a:pt x="287" y="1679"/>
                  </a:lnTo>
                  <a:lnTo>
                    <a:pt x="294" y="1672"/>
                  </a:lnTo>
                  <a:lnTo>
                    <a:pt x="301" y="1672"/>
                  </a:lnTo>
                  <a:lnTo>
                    <a:pt x="308" y="1672"/>
                  </a:lnTo>
                  <a:lnTo>
                    <a:pt x="315" y="1679"/>
                  </a:lnTo>
                  <a:lnTo>
                    <a:pt x="322" y="1679"/>
                  </a:lnTo>
                  <a:lnTo>
                    <a:pt x="329" y="1679"/>
                  </a:lnTo>
                  <a:lnTo>
                    <a:pt x="336" y="1672"/>
                  </a:lnTo>
                  <a:lnTo>
                    <a:pt x="343" y="1665"/>
                  </a:lnTo>
                  <a:lnTo>
                    <a:pt x="350" y="1665"/>
                  </a:lnTo>
                  <a:lnTo>
                    <a:pt x="357" y="1679"/>
                  </a:lnTo>
                  <a:lnTo>
                    <a:pt x="364" y="1679"/>
                  </a:lnTo>
                  <a:lnTo>
                    <a:pt x="371" y="1679"/>
                  </a:lnTo>
                  <a:lnTo>
                    <a:pt x="378" y="1679"/>
                  </a:lnTo>
                  <a:lnTo>
                    <a:pt x="385" y="1672"/>
                  </a:lnTo>
                  <a:lnTo>
                    <a:pt x="392" y="1672"/>
                  </a:lnTo>
                  <a:lnTo>
                    <a:pt x="399" y="1672"/>
                  </a:lnTo>
                  <a:lnTo>
                    <a:pt x="406" y="1672"/>
                  </a:lnTo>
                  <a:lnTo>
                    <a:pt x="413" y="1665"/>
                  </a:lnTo>
                  <a:lnTo>
                    <a:pt x="420" y="1665"/>
                  </a:lnTo>
                  <a:lnTo>
                    <a:pt x="427" y="1665"/>
                  </a:lnTo>
                  <a:lnTo>
                    <a:pt x="434" y="1658"/>
                  </a:lnTo>
                  <a:lnTo>
                    <a:pt x="441" y="1658"/>
                  </a:lnTo>
                  <a:lnTo>
                    <a:pt x="448" y="1658"/>
                  </a:lnTo>
                  <a:lnTo>
                    <a:pt x="455" y="1665"/>
                  </a:lnTo>
                  <a:lnTo>
                    <a:pt x="462" y="1665"/>
                  </a:lnTo>
                  <a:lnTo>
                    <a:pt x="469" y="1665"/>
                  </a:lnTo>
                  <a:lnTo>
                    <a:pt x="476" y="1665"/>
                  </a:lnTo>
                  <a:lnTo>
                    <a:pt x="483" y="1658"/>
                  </a:lnTo>
                  <a:lnTo>
                    <a:pt x="490" y="1658"/>
                  </a:lnTo>
                  <a:lnTo>
                    <a:pt x="497" y="1651"/>
                  </a:lnTo>
                  <a:lnTo>
                    <a:pt x="504" y="1637"/>
                  </a:lnTo>
                  <a:lnTo>
                    <a:pt x="511" y="1630"/>
                  </a:lnTo>
                  <a:lnTo>
                    <a:pt x="518" y="1623"/>
                  </a:lnTo>
                  <a:lnTo>
                    <a:pt x="525" y="1623"/>
                  </a:lnTo>
                  <a:lnTo>
                    <a:pt x="532" y="1609"/>
                  </a:lnTo>
                  <a:lnTo>
                    <a:pt x="539" y="1609"/>
                  </a:lnTo>
                  <a:lnTo>
                    <a:pt x="546" y="1609"/>
                  </a:lnTo>
                  <a:lnTo>
                    <a:pt x="553" y="1602"/>
                  </a:lnTo>
                  <a:lnTo>
                    <a:pt x="560" y="1602"/>
                  </a:lnTo>
                  <a:lnTo>
                    <a:pt x="567" y="1602"/>
                  </a:lnTo>
                  <a:lnTo>
                    <a:pt x="574" y="1588"/>
                  </a:lnTo>
                  <a:lnTo>
                    <a:pt x="581" y="1574"/>
                  </a:lnTo>
                  <a:lnTo>
                    <a:pt x="588" y="1553"/>
                  </a:lnTo>
                  <a:lnTo>
                    <a:pt x="595" y="1539"/>
                  </a:lnTo>
                  <a:lnTo>
                    <a:pt x="602" y="1539"/>
                  </a:lnTo>
                  <a:lnTo>
                    <a:pt x="609" y="1546"/>
                  </a:lnTo>
                  <a:lnTo>
                    <a:pt x="616" y="1553"/>
                  </a:lnTo>
                  <a:lnTo>
                    <a:pt x="623" y="1553"/>
                  </a:lnTo>
                  <a:lnTo>
                    <a:pt x="630" y="1539"/>
                  </a:lnTo>
                  <a:lnTo>
                    <a:pt x="637" y="1511"/>
                  </a:lnTo>
                  <a:lnTo>
                    <a:pt x="644" y="1497"/>
                  </a:lnTo>
                  <a:lnTo>
                    <a:pt x="651" y="1490"/>
                  </a:lnTo>
                  <a:lnTo>
                    <a:pt x="658" y="1469"/>
                  </a:lnTo>
                  <a:lnTo>
                    <a:pt x="665" y="1434"/>
                  </a:lnTo>
                  <a:lnTo>
                    <a:pt x="672" y="1420"/>
                  </a:lnTo>
                  <a:lnTo>
                    <a:pt x="679" y="1434"/>
                  </a:lnTo>
                  <a:lnTo>
                    <a:pt x="686" y="1448"/>
                  </a:lnTo>
                  <a:lnTo>
                    <a:pt x="693" y="1427"/>
                  </a:lnTo>
                  <a:lnTo>
                    <a:pt x="700" y="1385"/>
                  </a:lnTo>
                  <a:lnTo>
                    <a:pt x="707" y="1336"/>
                  </a:lnTo>
                  <a:lnTo>
                    <a:pt x="714" y="1301"/>
                  </a:lnTo>
                  <a:lnTo>
                    <a:pt x="721" y="1287"/>
                  </a:lnTo>
                  <a:lnTo>
                    <a:pt x="728" y="1287"/>
                  </a:lnTo>
                  <a:lnTo>
                    <a:pt x="735" y="1287"/>
                  </a:lnTo>
                  <a:lnTo>
                    <a:pt x="742" y="1273"/>
                  </a:lnTo>
                  <a:lnTo>
                    <a:pt x="749" y="1252"/>
                  </a:lnTo>
                  <a:lnTo>
                    <a:pt x="756" y="1161"/>
                  </a:lnTo>
                  <a:lnTo>
                    <a:pt x="763" y="1070"/>
                  </a:lnTo>
                  <a:lnTo>
                    <a:pt x="770" y="1070"/>
                  </a:lnTo>
                  <a:lnTo>
                    <a:pt x="777" y="1000"/>
                  </a:lnTo>
                  <a:lnTo>
                    <a:pt x="784" y="895"/>
                  </a:lnTo>
                  <a:lnTo>
                    <a:pt x="791" y="958"/>
                  </a:lnTo>
                  <a:lnTo>
                    <a:pt x="798" y="951"/>
                  </a:lnTo>
                  <a:lnTo>
                    <a:pt x="805" y="839"/>
                  </a:lnTo>
                  <a:lnTo>
                    <a:pt x="812" y="790"/>
                  </a:lnTo>
                  <a:lnTo>
                    <a:pt x="819" y="692"/>
                  </a:lnTo>
                  <a:lnTo>
                    <a:pt x="826" y="713"/>
                  </a:lnTo>
                  <a:lnTo>
                    <a:pt x="833" y="790"/>
                  </a:lnTo>
                  <a:lnTo>
                    <a:pt x="840" y="664"/>
                  </a:lnTo>
                  <a:lnTo>
                    <a:pt x="847" y="511"/>
                  </a:lnTo>
                  <a:lnTo>
                    <a:pt x="854" y="483"/>
                  </a:lnTo>
                  <a:lnTo>
                    <a:pt x="861" y="448"/>
                  </a:lnTo>
                  <a:lnTo>
                    <a:pt x="868" y="434"/>
                  </a:lnTo>
                  <a:lnTo>
                    <a:pt x="875" y="455"/>
                  </a:lnTo>
                  <a:lnTo>
                    <a:pt x="882" y="517"/>
                  </a:lnTo>
                  <a:lnTo>
                    <a:pt x="889" y="545"/>
                  </a:lnTo>
                  <a:lnTo>
                    <a:pt x="896" y="392"/>
                  </a:lnTo>
                  <a:lnTo>
                    <a:pt x="903" y="210"/>
                  </a:lnTo>
                  <a:lnTo>
                    <a:pt x="910" y="175"/>
                  </a:lnTo>
                  <a:lnTo>
                    <a:pt x="917" y="105"/>
                  </a:lnTo>
                  <a:lnTo>
                    <a:pt x="924" y="168"/>
                  </a:lnTo>
                  <a:lnTo>
                    <a:pt x="931" y="112"/>
                  </a:lnTo>
                  <a:lnTo>
                    <a:pt x="938" y="21"/>
                  </a:lnTo>
                  <a:lnTo>
                    <a:pt x="945" y="0"/>
                  </a:lnTo>
                  <a:lnTo>
                    <a:pt x="952" y="35"/>
                  </a:lnTo>
                  <a:lnTo>
                    <a:pt x="959" y="91"/>
                  </a:lnTo>
                  <a:lnTo>
                    <a:pt x="966" y="161"/>
                  </a:lnTo>
                  <a:lnTo>
                    <a:pt x="973" y="196"/>
                  </a:lnTo>
                  <a:lnTo>
                    <a:pt x="980" y="126"/>
                  </a:lnTo>
                  <a:lnTo>
                    <a:pt x="987" y="14"/>
                  </a:lnTo>
                  <a:lnTo>
                    <a:pt x="994" y="70"/>
                  </a:lnTo>
                  <a:lnTo>
                    <a:pt x="1001" y="252"/>
                  </a:lnTo>
                  <a:lnTo>
                    <a:pt x="1008" y="294"/>
                  </a:lnTo>
                  <a:lnTo>
                    <a:pt x="1015" y="252"/>
                  </a:lnTo>
                  <a:lnTo>
                    <a:pt x="1022" y="231"/>
                  </a:lnTo>
                  <a:lnTo>
                    <a:pt x="1029" y="196"/>
                  </a:lnTo>
                  <a:lnTo>
                    <a:pt x="1036" y="259"/>
                  </a:lnTo>
                  <a:lnTo>
                    <a:pt x="1043" y="371"/>
                  </a:lnTo>
                  <a:lnTo>
                    <a:pt x="1050" y="357"/>
                  </a:lnTo>
                  <a:lnTo>
                    <a:pt x="1057" y="364"/>
                  </a:lnTo>
                  <a:lnTo>
                    <a:pt x="1064" y="364"/>
                  </a:lnTo>
                  <a:lnTo>
                    <a:pt x="1071" y="371"/>
                  </a:lnTo>
                  <a:lnTo>
                    <a:pt x="1078" y="413"/>
                  </a:lnTo>
                  <a:lnTo>
                    <a:pt x="1085" y="406"/>
                  </a:lnTo>
                  <a:lnTo>
                    <a:pt x="1092" y="441"/>
                  </a:lnTo>
                  <a:lnTo>
                    <a:pt x="1099" y="392"/>
                  </a:lnTo>
                  <a:lnTo>
                    <a:pt x="1106" y="364"/>
                  </a:lnTo>
                  <a:lnTo>
                    <a:pt x="1113" y="469"/>
                  </a:lnTo>
                  <a:lnTo>
                    <a:pt x="1120" y="573"/>
                  </a:lnTo>
                  <a:lnTo>
                    <a:pt x="1127" y="615"/>
                  </a:lnTo>
                  <a:lnTo>
                    <a:pt x="1134" y="643"/>
                  </a:lnTo>
                  <a:lnTo>
                    <a:pt x="1141" y="615"/>
                  </a:lnTo>
                  <a:lnTo>
                    <a:pt x="1148" y="594"/>
                  </a:lnTo>
                  <a:lnTo>
                    <a:pt x="1155" y="615"/>
                  </a:lnTo>
                  <a:lnTo>
                    <a:pt x="1162" y="594"/>
                  </a:lnTo>
                  <a:lnTo>
                    <a:pt x="1169" y="601"/>
                  </a:lnTo>
                  <a:lnTo>
                    <a:pt x="1176" y="706"/>
                  </a:lnTo>
                  <a:lnTo>
                    <a:pt x="1183" y="790"/>
                  </a:lnTo>
                  <a:lnTo>
                    <a:pt x="1190" y="818"/>
                  </a:lnTo>
                  <a:lnTo>
                    <a:pt x="1197" y="811"/>
                  </a:lnTo>
                  <a:lnTo>
                    <a:pt x="1203" y="825"/>
                  </a:lnTo>
                  <a:lnTo>
                    <a:pt x="1210" y="846"/>
                  </a:lnTo>
                  <a:lnTo>
                    <a:pt x="1217" y="881"/>
                  </a:lnTo>
                  <a:lnTo>
                    <a:pt x="1224" y="888"/>
                  </a:lnTo>
                  <a:lnTo>
                    <a:pt x="1231" y="888"/>
                  </a:lnTo>
                  <a:lnTo>
                    <a:pt x="1238" y="881"/>
                  </a:lnTo>
                  <a:lnTo>
                    <a:pt x="1245" y="874"/>
                  </a:lnTo>
                  <a:lnTo>
                    <a:pt x="1252" y="881"/>
                  </a:lnTo>
                  <a:lnTo>
                    <a:pt x="1259" y="937"/>
                  </a:lnTo>
                  <a:lnTo>
                    <a:pt x="1266" y="993"/>
                  </a:lnTo>
                  <a:lnTo>
                    <a:pt x="1273" y="1014"/>
                  </a:lnTo>
                  <a:lnTo>
                    <a:pt x="1280" y="1028"/>
                  </a:lnTo>
                  <a:lnTo>
                    <a:pt x="1287" y="1007"/>
                  </a:lnTo>
                  <a:lnTo>
                    <a:pt x="1294" y="986"/>
                  </a:lnTo>
                  <a:lnTo>
                    <a:pt x="1301" y="1021"/>
                  </a:lnTo>
                  <a:lnTo>
                    <a:pt x="1308" y="1084"/>
                  </a:lnTo>
                  <a:lnTo>
                    <a:pt x="1315" y="1119"/>
                  </a:lnTo>
                  <a:lnTo>
                    <a:pt x="1322" y="1140"/>
                  </a:lnTo>
                  <a:lnTo>
                    <a:pt x="1329" y="1140"/>
                  </a:lnTo>
                  <a:lnTo>
                    <a:pt x="1336" y="1175"/>
                  </a:lnTo>
                  <a:lnTo>
                    <a:pt x="1343" y="1203"/>
                  </a:lnTo>
                  <a:lnTo>
                    <a:pt x="1350" y="1217"/>
                  </a:lnTo>
                  <a:lnTo>
                    <a:pt x="1357" y="1224"/>
                  </a:lnTo>
                  <a:lnTo>
                    <a:pt x="1364" y="1210"/>
                  </a:lnTo>
                  <a:lnTo>
                    <a:pt x="1371" y="1196"/>
                  </a:lnTo>
                  <a:lnTo>
                    <a:pt x="1378" y="1203"/>
                  </a:lnTo>
                  <a:lnTo>
                    <a:pt x="1385" y="1245"/>
                  </a:lnTo>
                  <a:lnTo>
                    <a:pt x="1392" y="1287"/>
                  </a:lnTo>
                  <a:lnTo>
                    <a:pt x="1399" y="1301"/>
                  </a:lnTo>
                  <a:lnTo>
                    <a:pt x="1406" y="1308"/>
                  </a:lnTo>
                  <a:lnTo>
                    <a:pt x="1413" y="1308"/>
                  </a:lnTo>
                  <a:lnTo>
                    <a:pt x="1420" y="1322"/>
                  </a:lnTo>
                  <a:lnTo>
                    <a:pt x="1427" y="1357"/>
                  </a:lnTo>
                  <a:lnTo>
                    <a:pt x="1434" y="1385"/>
                  </a:lnTo>
                  <a:lnTo>
                    <a:pt x="1441" y="1413"/>
                  </a:lnTo>
                  <a:lnTo>
                    <a:pt x="1448" y="1434"/>
                  </a:lnTo>
                  <a:lnTo>
                    <a:pt x="1455" y="1448"/>
                  </a:lnTo>
                  <a:lnTo>
                    <a:pt x="1462" y="1462"/>
                  </a:lnTo>
                  <a:lnTo>
                    <a:pt x="1469" y="1476"/>
                  </a:lnTo>
                  <a:lnTo>
                    <a:pt x="1476" y="1483"/>
                  </a:lnTo>
                  <a:lnTo>
                    <a:pt x="1483" y="1476"/>
                  </a:lnTo>
                  <a:lnTo>
                    <a:pt x="1490" y="1476"/>
                  </a:lnTo>
                  <a:lnTo>
                    <a:pt x="1497" y="1497"/>
                  </a:lnTo>
                  <a:lnTo>
                    <a:pt x="1504" y="1525"/>
                  </a:lnTo>
                  <a:lnTo>
                    <a:pt x="1511" y="1546"/>
                  </a:lnTo>
                  <a:lnTo>
                    <a:pt x="1518" y="1574"/>
                  </a:lnTo>
                  <a:lnTo>
                    <a:pt x="1525" y="1588"/>
                  </a:lnTo>
                  <a:lnTo>
                    <a:pt x="1532" y="1595"/>
                  </a:lnTo>
                  <a:lnTo>
                    <a:pt x="1539" y="1595"/>
                  </a:lnTo>
                  <a:lnTo>
                    <a:pt x="1546" y="1595"/>
                  </a:lnTo>
                  <a:lnTo>
                    <a:pt x="1553" y="1595"/>
                  </a:lnTo>
                  <a:lnTo>
                    <a:pt x="1560" y="1595"/>
                  </a:lnTo>
                  <a:lnTo>
                    <a:pt x="1567" y="1595"/>
                  </a:lnTo>
                  <a:lnTo>
                    <a:pt x="1574" y="1602"/>
                  </a:lnTo>
                  <a:lnTo>
                    <a:pt x="1581" y="1616"/>
                  </a:lnTo>
                  <a:lnTo>
                    <a:pt x="1588" y="1630"/>
                  </a:lnTo>
                  <a:lnTo>
                    <a:pt x="1595" y="1637"/>
                  </a:lnTo>
                  <a:lnTo>
                    <a:pt x="1602" y="1651"/>
                  </a:lnTo>
                  <a:lnTo>
                    <a:pt x="1609" y="1651"/>
                  </a:lnTo>
                  <a:lnTo>
                    <a:pt x="1616" y="1651"/>
                  </a:lnTo>
                  <a:lnTo>
                    <a:pt x="1623" y="1651"/>
                  </a:lnTo>
                  <a:lnTo>
                    <a:pt x="1630" y="1644"/>
                  </a:lnTo>
                  <a:lnTo>
                    <a:pt x="1637" y="1644"/>
                  </a:lnTo>
                  <a:lnTo>
                    <a:pt x="1644" y="1651"/>
                  </a:lnTo>
                  <a:lnTo>
                    <a:pt x="1651" y="1658"/>
                  </a:lnTo>
                  <a:lnTo>
                    <a:pt x="1658" y="1658"/>
                  </a:lnTo>
                  <a:lnTo>
                    <a:pt x="1665" y="1665"/>
                  </a:lnTo>
                  <a:lnTo>
                    <a:pt x="1672" y="1665"/>
                  </a:lnTo>
                  <a:lnTo>
                    <a:pt x="1679" y="1672"/>
                  </a:lnTo>
                  <a:lnTo>
                    <a:pt x="1686" y="1672"/>
                  </a:lnTo>
                  <a:lnTo>
                    <a:pt x="1693" y="1672"/>
                  </a:lnTo>
                  <a:lnTo>
                    <a:pt x="1700" y="1672"/>
                  </a:lnTo>
                  <a:lnTo>
                    <a:pt x="1707" y="1672"/>
                  </a:lnTo>
                  <a:lnTo>
                    <a:pt x="1714" y="1672"/>
                  </a:lnTo>
                  <a:lnTo>
                    <a:pt x="1721" y="1672"/>
                  </a:lnTo>
                  <a:lnTo>
                    <a:pt x="1728" y="1672"/>
                  </a:lnTo>
                  <a:lnTo>
                    <a:pt x="1735" y="1672"/>
                  </a:lnTo>
                  <a:lnTo>
                    <a:pt x="1742" y="1672"/>
                  </a:lnTo>
                  <a:lnTo>
                    <a:pt x="1749" y="1672"/>
                  </a:lnTo>
                  <a:lnTo>
                    <a:pt x="1756" y="1630"/>
                  </a:lnTo>
                  <a:lnTo>
                    <a:pt x="1763" y="1462"/>
                  </a:lnTo>
                  <a:lnTo>
                    <a:pt x="1770" y="1140"/>
                  </a:lnTo>
                  <a:lnTo>
                    <a:pt x="1777" y="916"/>
                  </a:lnTo>
                </a:path>
              </a:pathLst>
            </a:custGeom>
            <a:noFill/>
            <a:ln w="11113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695" name="Line 92"/>
            <p:cNvSpPr>
              <a:spLocks noChangeShapeType="1"/>
            </p:cNvSpPr>
            <p:nvPr/>
          </p:nvSpPr>
          <p:spPr bwMode="auto">
            <a:xfrm flipV="1">
              <a:off x="3549454" y="911125"/>
              <a:ext cx="3036" cy="143675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ja-JP" altLang="en-US" sz="800">
                <a:latin typeface="Arial" panose="020B0604020202020204" pitchFamily="34" charset="0"/>
                <a:ea typeface="ＭＳ Ｐゴシック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696" name="Line 100"/>
            <p:cNvSpPr>
              <a:spLocks noChangeShapeType="1"/>
            </p:cNvSpPr>
            <p:nvPr/>
          </p:nvSpPr>
          <p:spPr bwMode="auto">
            <a:xfrm flipH="1">
              <a:off x="3510488" y="2340765"/>
              <a:ext cx="3645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ja-JP" altLang="en-US" sz="800">
                <a:latin typeface="Arial" panose="020B0604020202020204" pitchFamily="34" charset="0"/>
                <a:ea typeface="ＭＳ Ｐゴシック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697" name="Line 104"/>
            <p:cNvSpPr>
              <a:spLocks noChangeShapeType="1"/>
            </p:cNvSpPr>
            <p:nvPr/>
          </p:nvSpPr>
          <p:spPr bwMode="auto">
            <a:xfrm flipH="1">
              <a:off x="3503891" y="2074503"/>
              <a:ext cx="432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ja-JP" altLang="en-US" sz="800">
                <a:latin typeface="Arial" panose="020B0604020202020204" pitchFamily="34" charset="0"/>
                <a:ea typeface="ＭＳ Ｐゴシック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698" name="Line 108"/>
            <p:cNvSpPr>
              <a:spLocks noChangeShapeType="1"/>
            </p:cNvSpPr>
            <p:nvPr/>
          </p:nvSpPr>
          <p:spPr bwMode="auto">
            <a:xfrm flipH="1">
              <a:off x="3503891" y="1801125"/>
              <a:ext cx="432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ja-JP" altLang="en-US" sz="800">
                <a:latin typeface="Arial" panose="020B0604020202020204" pitchFamily="34" charset="0"/>
                <a:ea typeface="ＭＳ Ｐゴシック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699" name="Line 112"/>
            <p:cNvSpPr>
              <a:spLocks noChangeShapeType="1"/>
            </p:cNvSpPr>
            <p:nvPr/>
          </p:nvSpPr>
          <p:spPr bwMode="auto">
            <a:xfrm flipH="1">
              <a:off x="3503891" y="1521669"/>
              <a:ext cx="432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ja-JP" altLang="en-US" sz="800">
                <a:latin typeface="Arial" panose="020B0604020202020204" pitchFamily="34" charset="0"/>
                <a:ea typeface="ＭＳ Ｐゴシック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00" name="Line 116"/>
            <p:cNvSpPr>
              <a:spLocks noChangeShapeType="1"/>
            </p:cNvSpPr>
            <p:nvPr/>
          </p:nvSpPr>
          <p:spPr bwMode="auto">
            <a:xfrm flipH="1">
              <a:off x="3503891" y="1251329"/>
              <a:ext cx="432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ja-JP" altLang="en-US" sz="800">
                <a:latin typeface="Arial" panose="020B0604020202020204" pitchFamily="34" charset="0"/>
                <a:ea typeface="ＭＳ Ｐゴシック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01" name="Line 120"/>
            <p:cNvSpPr>
              <a:spLocks noChangeShapeType="1"/>
            </p:cNvSpPr>
            <p:nvPr/>
          </p:nvSpPr>
          <p:spPr bwMode="auto">
            <a:xfrm flipH="1">
              <a:off x="3503891" y="977951"/>
              <a:ext cx="432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ja-JP" altLang="en-US" sz="800">
                <a:latin typeface="Arial" panose="020B0604020202020204" pitchFamily="34" charset="0"/>
                <a:ea typeface="ＭＳ Ｐゴシック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04" name="Rectangle 515"/>
            <p:cNvSpPr>
              <a:spLocks noChangeArrowheads="1"/>
            </p:cNvSpPr>
            <p:nvPr/>
          </p:nvSpPr>
          <p:spPr bwMode="auto">
            <a:xfrm>
              <a:off x="3151701" y="2772596"/>
              <a:ext cx="462344" cy="123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36000" tIns="0" rIns="36000" bIns="0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en-US" altLang="ja-JP" sz="800" dirty="0">
                  <a:latin typeface="Arial" panose="020B0604020202020204" pitchFamily="34" charset="0"/>
                  <a:ea typeface="ＭＳ Ｐゴシック" pitchFamily="84" charset="-128"/>
                  <a:cs typeface="Arial" panose="020B0604020202020204" pitchFamily="34" charset="0"/>
                </a:rPr>
                <a:t>Non-</a:t>
              </a:r>
              <a:r>
                <a:rPr lang="en-US" altLang="ja-JP" sz="800" dirty="0" err="1">
                  <a:latin typeface="Arial" panose="020B0604020202020204" pitchFamily="34" charset="0"/>
                  <a:ea typeface="ＭＳ Ｐゴシック" pitchFamily="84" charset="-128"/>
                  <a:cs typeface="Arial" panose="020B0604020202020204" pitchFamily="34" charset="0"/>
                </a:rPr>
                <a:t>Tg</a:t>
              </a:r>
              <a:endParaRPr lang="en-US" altLang="ja-JP" sz="800" dirty="0">
                <a:latin typeface="Arial" panose="020B0604020202020204" pitchFamily="34" charset="0"/>
                <a:ea typeface="ＭＳ Ｐゴシック" pitchFamily="84" charset="-128"/>
                <a:cs typeface="Arial" panose="020B0604020202020204" pitchFamily="34" charset="0"/>
              </a:endParaRPr>
            </a:p>
          </p:txBody>
        </p:sp>
        <p:sp>
          <p:nvSpPr>
            <p:cNvPr id="705" name="Rectangle 516"/>
            <p:cNvSpPr>
              <a:spLocks noChangeArrowheads="1"/>
            </p:cNvSpPr>
            <p:nvPr/>
          </p:nvSpPr>
          <p:spPr bwMode="auto">
            <a:xfrm>
              <a:off x="4123779" y="2772596"/>
              <a:ext cx="502312" cy="123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36000" tIns="0" rIns="36000" bIns="0" anchor="ctr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BZ-</a:t>
              </a:r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Tg</a:t>
              </a:r>
              <a:endParaRPr lang="en-US" altLang="ja-JP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6" name="Line 402"/>
            <p:cNvSpPr>
              <a:spLocks noChangeShapeType="1"/>
            </p:cNvSpPr>
            <p:nvPr/>
          </p:nvSpPr>
          <p:spPr bwMode="auto">
            <a:xfrm>
              <a:off x="3836889" y="2834151"/>
              <a:ext cx="275531" cy="0"/>
            </a:xfrm>
            <a:prstGeom prst="line">
              <a:avLst/>
            </a:prstGeom>
            <a:noFill/>
            <a:ln w="28575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 dirty="0"/>
            </a:p>
          </p:txBody>
        </p:sp>
        <p:cxnSp>
          <p:nvCxnSpPr>
            <p:cNvPr id="707" name="直線矢印コネクタ 706"/>
            <p:cNvCxnSpPr/>
            <p:nvPr/>
          </p:nvCxnSpPr>
          <p:spPr bwMode="auto">
            <a:xfrm flipV="1">
              <a:off x="2061642" y="2582259"/>
              <a:ext cx="2737719" cy="0"/>
            </a:xfrm>
            <a:prstGeom prst="straightConnector1">
              <a:avLst/>
            </a:prstGeom>
            <a:ln w="6350" cmpd="sng">
              <a:solidFill>
                <a:schemeClr val="bg2">
                  <a:lumMod val="10000"/>
                </a:schemeClr>
              </a:solidFill>
              <a:headEnd type="none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08" name="テキスト ボックス 74"/>
            <p:cNvSpPr txBox="1">
              <a:spLocks noChangeAspect="1" noChangeArrowheads="1"/>
            </p:cNvSpPr>
            <p:nvPr/>
          </p:nvSpPr>
          <p:spPr bwMode="auto">
            <a:xfrm>
              <a:off x="1699461" y="2487020"/>
              <a:ext cx="362181" cy="1958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36000" rIns="0" bIns="36000"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Arial Unicode MS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9pPr>
            </a:lstStyle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PD-1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0" name="Line 92"/>
            <p:cNvSpPr>
              <a:spLocks noChangeShapeType="1"/>
            </p:cNvSpPr>
            <p:nvPr/>
          </p:nvSpPr>
          <p:spPr bwMode="auto">
            <a:xfrm flipV="1">
              <a:off x="1671430" y="904585"/>
              <a:ext cx="3036" cy="143675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ja-JP" altLang="en-US" sz="800">
                <a:latin typeface="Arial" panose="020B0604020202020204" pitchFamily="34" charset="0"/>
                <a:ea typeface="ＭＳ Ｐゴシック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11" name="Line 100"/>
            <p:cNvSpPr>
              <a:spLocks noChangeShapeType="1"/>
            </p:cNvSpPr>
            <p:nvPr/>
          </p:nvSpPr>
          <p:spPr bwMode="auto">
            <a:xfrm flipH="1">
              <a:off x="1628906" y="2343681"/>
              <a:ext cx="3645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ja-JP" altLang="en-US" sz="800">
                <a:latin typeface="Arial" panose="020B0604020202020204" pitchFamily="34" charset="0"/>
                <a:ea typeface="ＭＳ Ｐゴシック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12" name="Line 104"/>
            <p:cNvSpPr>
              <a:spLocks noChangeShapeType="1"/>
            </p:cNvSpPr>
            <p:nvPr/>
          </p:nvSpPr>
          <p:spPr bwMode="auto">
            <a:xfrm flipH="1">
              <a:off x="1625867" y="2074761"/>
              <a:ext cx="432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ja-JP" altLang="en-US" sz="800">
                <a:latin typeface="Arial" panose="020B0604020202020204" pitchFamily="34" charset="0"/>
                <a:ea typeface="ＭＳ Ｐゴシック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13" name="Line 108"/>
            <p:cNvSpPr>
              <a:spLocks noChangeShapeType="1"/>
            </p:cNvSpPr>
            <p:nvPr/>
          </p:nvSpPr>
          <p:spPr bwMode="auto">
            <a:xfrm flipH="1">
              <a:off x="1625867" y="1801383"/>
              <a:ext cx="432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ja-JP" altLang="en-US" sz="800">
                <a:latin typeface="Arial" panose="020B0604020202020204" pitchFamily="34" charset="0"/>
                <a:ea typeface="ＭＳ Ｐゴシック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14" name="Line 112"/>
            <p:cNvSpPr>
              <a:spLocks noChangeShapeType="1"/>
            </p:cNvSpPr>
            <p:nvPr/>
          </p:nvSpPr>
          <p:spPr bwMode="auto">
            <a:xfrm flipH="1">
              <a:off x="1625867" y="1521927"/>
              <a:ext cx="432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ja-JP" altLang="en-US" sz="800">
                <a:latin typeface="Arial" panose="020B0604020202020204" pitchFamily="34" charset="0"/>
                <a:ea typeface="ＭＳ Ｐゴシック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15" name="Line 116"/>
            <p:cNvSpPr>
              <a:spLocks noChangeShapeType="1"/>
            </p:cNvSpPr>
            <p:nvPr/>
          </p:nvSpPr>
          <p:spPr bwMode="auto">
            <a:xfrm flipH="1">
              <a:off x="1625867" y="1251587"/>
              <a:ext cx="432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ja-JP" altLang="en-US" sz="800">
                <a:latin typeface="Arial" panose="020B0604020202020204" pitchFamily="34" charset="0"/>
                <a:ea typeface="ＭＳ Ｐゴシック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16" name="Line 120"/>
            <p:cNvSpPr>
              <a:spLocks noChangeShapeType="1"/>
            </p:cNvSpPr>
            <p:nvPr/>
          </p:nvSpPr>
          <p:spPr bwMode="auto">
            <a:xfrm flipH="1">
              <a:off x="1625867" y="978209"/>
              <a:ext cx="432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ja-JP" altLang="en-US" sz="800">
                <a:latin typeface="Arial" panose="020B0604020202020204" pitchFamily="34" charset="0"/>
                <a:ea typeface="ＭＳ Ｐゴシック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18" name="Rectangle 25"/>
            <p:cNvSpPr>
              <a:spLocks noChangeArrowheads="1"/>
            </p:cNvSpPr>
            <p:nvPr/>
          </p:nvSpPr>
          <p:spPr bwMode="auto">
            <a:xfrm>
              <a:off x="1989634" y="2777020"/>
              <a:ext cx="190515" cy="118686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19" name="Rectangle 76"/>
            <p:cNvSpPr>
              <a:spLocks noChangeArrowheads="1"/>
            </p:cNvSpPr>
            <p:nvPr/>
          </p:nvSpPr>
          <p:spPr bwMode="auto">
            <a:xfrm>
              <a:off x="2244903" y="2772594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I</a:t>
              </a: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sotype</a:t>
              </a:r>
              <a:endParaRPr lang="en-US" altLang="ja-JP" sz="8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20" name="Line 402"/>
            <p:cNvSpPr>
              <a:spLocks noChangeShapeType="1"/>
            </p:cNvSpPr>
            <p:nvPr/>
          </p:nvSpPr>
          <p:spPr bwMode="auto">
            <a:xfrm>
              <a:off x="2839335" y="2834151"/>
              <a:ext cx="275531" cy="0"/>
            </a:xfrm>
            <a:prstGeom prst="line">
              <a:avLst/>
            </a:prstGeom>
            <a:noFill/>
            <a:ln w="2857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 dirty="0"/>
            </a:p>
          </p:txBody>
        </p:sp>
        <p:sp>
          <p:nvSpPr>
            <p:cNvPr id="721" name="Rectangle 93"/>
            <p:cNvSpPr>
              <a:spLocks noChangeArrowheads="1"/>
            </p:cNvSpPr>
            <p:nvPr/>
          </p:nvSpPr>
          <p:spPr bwMode="auto">
            <a:xfrm>
              <a:off x="1485578" y="2265683"/>
              <a:ext cx="8046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2" name="Rectangle 94"/>
            <p:cNvSpPr>
              <a:spLocks noChangeArrowheads="1"/>
            </p:cNvSpPr>
            <p:nvPr/>
          </p:nvSpPr>
          <p:spPr bwMode="auto">
            <a:xfrm>
              <a:off x="1413570" y="2010620"/>
              <a:ext cx="1609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3" name="Rectangle 95"/>
            <p:cNvSpPr>
              <a:spLocks noChangeArrowheads="1"/>
            </p:cNvSpPr>
            <p:nvPr/>
          </p:nvSpPr>
          <p:spPr bwMode="auto">
            <a:xfrm>
              <a:off x="1417047" y="1740553"/>
              <a:ext cx="1609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US" altLang="ja-JP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4" name="Rectangle 96"/>
            <p:cNvSpPr>
              <a:spLocks noChangeArrowheads="1"/>
            </p:cNvSpPr>
            <p:nvPr/>
          </p:nvSpPr>
          <p:spPr bwMode="auto">
            <a:xfrm>
              <a:off x="1420525" y="1467009"/>
              <a:ext cx="1609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en-US" altLang="ja-JP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5" name="Rectangle 97"/>
            <p:cNvSpPr>
              <a:spLocks noChangeArrowheads="1"/>
            </p:cNvSpPr>
            <p:nvPr/>
          </p:nvSpPr>
          <p:spPr bwMode="auto">
            <a:xfrm>
              <a:off x="1420525" y="1188418"/>
              <a:ext cx="1609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6" name="Rectangle 98"/>
            <p:cNvSpPr>
              <a:spLocks noChangeArrowheads="1"/>
            </p:cNvSpPr>
            <p:nvPr/>
          </p:nvSpPr>
          <p:spPr bwMode="auto">
            <a:xfrm>
              <a:off x="1388188" y="916017"/>
              <a:ext cx="24140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7" name="Rectangle 93"/>
            <p:cNvSpPr>
              <a:spLocks noChangeArrowheads="1"/>
            </p:cNvSpPr>
            <p:nvPr/>
          </p:nvSpPr>
          <p:spPr bwMode="auto">
            <a:xfrm>
              <a:off x="3357786" y="2263960"/>
              <a:ext cx="8046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8" name="Rectangle 94"/>
            <p:cNvSpPr>
              <a:spLocks noChangeArrowheads="1"/>
            </p:cNvSpPr>
            <p:nvPr/>
          </p:nvSpPr>
          <p:spPr bwMode="auto">
            <a:xfrm>
              <a:off x="3285778" y="2008897"/>
              <a:ext cx="1609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9" name="Rectangle 95"/>
            <p:cNvSpPr>
              <a:spLocks noChangeArrowheads="1"/>
            </p:cNvSpPr>
            <p:nvPr/>
          </p:nvSpPr>
          <p:spPr bwMode="auto">
            <a:xfrm>
              <a:off x="3289255" y="1738830"/>
              <a:ext cx="1609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US" altLang="ja-JP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0" name="Rectangle 96"/>
            <p:cNvSpPr>
              <a:spLocks noChangeArrowheads="1"/>
            </p:cNvSpPr>
            <p:nvPr/>
          </p:nvSpPr>
          <p:spPr bwMode="auto">
            <a:xfrm>
              <a:off x="3292733" y="1465286"/>
              <a:ext cx="1609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en-US" altLang="ja-JP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1" name="Rectangle 97"/>
            <p:cNvSpPr>
              <a:spLocks noChangeArrowheads="1"/>
            </p:cNvSpPr>
            <p:nvPr/>
          </p:nvSpPr>
          <p:spPr bwMode="auto">
            <a:xfrm>
              <a:off x="3292733" y="1186695"/>
              <a:ext cx="1609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2" name="Rectangle 98"/>
            <p:cNvSpPr>
              <a:spLocks noChangeArrowheads="1"/>
            </p:cNvSpPr>
            <p:nvPr/>
          </p:nvSpPr>
          <p:spPr bwMode="auto">
            <a:xfrm>
              <a:off x="3260396" y="914294"/>
              <a:ext cx="24140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4" name="Rectangle 28"/>
            <p:cNvSpPr>
              <a:spLocks noChangeArrowheads="1"/>
            </p:cNvSpPr>
            <p:nvPr/>
          </p:nvSpPr>
          <p:spPr bwMode="auto">
            <a:xfrm rot="16200000">
              <a:off x="784612" y="1580629"/>
              <a:ext cx="92807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%</a:t>
              </a:r>
              <a:r>
                <a:rPr lang="ja-JP" altLang="en-US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f Max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4" name="Group 195"/>
            <p:cNvGrpSpPr>
              <a:grpSpLocks/>
            </p:cNvGrpSpPr>
            <p:nvPr/>
          </p:nvGrpSpPr>
          <p:grpSpPr bwMode="auto">
            <a:xfrm>
              <a:off x="4432977" y="1660248"/>
              <a:ext cx="538955" cy="66675"/>
              <a:chOff x="4622" y="2306"/>
              <a:chExt cx="679" cy="84"/>
            </a:xfrm>
          </p:grpSpPr>
          <p:sp>
            <p:nvSpPr>
              <p:cNvPr id="97" name="Line 192"/>
              <p:cNvSpPr>
                <a:spLocks noChangeShapeType="1"/>
              </p:cNvSpPr>
              <p:nvPr/>
            </p:nvSpPr>
            <p:spPr bwMode="auto">
              <a:xfrm>
                <a:off x="4622" y="2306"/>
                <a:ext cx="1" cy="8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98" name="Line 193"/>
              <p:cNvSpPr>
                <a:spLocks noChangeShapeType="1"/>
              </p:cNvSpPr>
              <p:nvPr/>
            </p:nvSpPr>
            <p:spPr bwMode="auto">
              <a:xfrm>
                <a:off x="5300" y="2306"/>
                <a:ext cx="1" cy="8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99" name="Line 194"/>
              <p:cNvSpPr>
                <a:spLocks noChangeShapeType="1"/>
              </p:cNvSpPr>
              <p:nvPr/>
            </p:nvSpPr>
            <p:spPr bwMode="auto">
              <a:xfrm>
                <a:off x="4622" y="2341"/>
                <a:ext cx="671" cy="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</p:grpSp>
        <p:sp>
          <p:nvSpPr>
            <p:cNvPr id="96" name="Rectangle 197"/>
            <p:cNvSpPr>
              <a:spLocks noChangeArrowheads="1"/>
            </p:cNvSpPr>
            <p:nvPr/>
          </p:nvSpPr>
          <p:spPr bwMode="auto">
            <a:xfrm>
              <a:off x="4548864" y="1464985"/>
              <a:ext cx="308768" cy="1690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r>
                <a:rPr lang="en-US" altLang="ja-JP" sz="1100" dirty="0">
                  <a:solidFill>
                    <a:srgbClr val="000000"/>
                  </a:solidFill>
                </a:rPr>
                <a:t>36.5</a:t>
              </a:r>
              <a:endParaRPr lang="en-US" altLang="ja-JP" dirty="0"/>
            </a:p>
          </p:txBody>
        </p:sp>
      </p:grpSp>
    </p:spTree>
    <p:extLst>
      <p:ext uri="{BB962C8B-B14F-4D97-AF65-F5344CB8AC3E}">
        <p14:creationId xmlns:p14="http://schemas.microsoft.com/office/powerpoint/2010/main" val="313939418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5</Words>
  <Application>Microsoft Macintosh PowerPoint</Application>
  <PresentationFormat>画面に合わせる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oka Masao</dc:creator>
  <cp:lastModifiedBy>Matsuoka Masao</cp:lastModifiedBy>
  <cp:revision>9</cp:revision>
  <dcterms:created xsi:type="dcterms:W3CDTF">2015-12-09T05:05:01Z</dcterms:created>
  <dcterms:modified xsi:type="dcterms:W3CDTF">2015-12-09T05:08:12Z</dcterms:modified>
</cp:coreProperties>
</file>